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75" r:id="rId2"/>
    <p:sldId id="262" r:id="rId3"/>
    <p:sldId id="266" r:id="rId4"/>
    <p:sldId id="271" r:id="rId5"/>
    <p:sldId id="264" r:id="rId6"/>
    <p:sldId id="268" r:id="rId7"/>
    <p:sldId id="273" r:id="rId8"/>
    <p:sldId id="263" r:id="rId9"/>
    <p:sldId id="267" r:id="rId10"/>
    <p:sldId id="272" r:id="rId11"/>
    <p:sldId id="265" r:id="rId12"/>
    <p:sldId id="269" r:id="rId13"/>
    <p:sldId id="274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6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7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8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9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0.xlsx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1.xlsx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2.xlsx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3.xlsx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4.xlsx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4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backup20140623\H27&#30330;&#34920;\&#23567;&#26519;&#28147;&#20108;&#20808;&#29983;&#12288;&#20849;&#21516;&#30740;&#31350;\20100209&#25220;&#37682;&#29992;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D$15:$AD$23</c:f>
              <c:numCache>
                <c:formatCode>General</c:formatCode>
                <c:ptCount val="9"/>
                <c:pt idx="0">
                  <c:v>-25.547445255474454</c:v>
                </c:pt>
                <c:pt idx="1">
                  <c:v>-31.111111111111111</c:v>
                </c:pt>
                <c:pt idx="2">
                  <c:v>-24.409448818897637</c:v>
                </c:pt>
                <c:pt idx="3">
                  <c:v>-6.666666666666667</c:v>
                </c:pt>
                <c:pt idx="4">
                  <c:v>-16.279069767441861</c:v>
                </c:pt>
                <c:pt idx="5">
                  <c:v>1.6260162601626018</c:v>
                </c:pt>
                <c:pt idx="6">
                  <c:v>-32.608695652173914</c:v>
                </c:pt>
                <c:pt idx="7">
                  <c:v>-16</c:v>
                </c:pt>
                <c:pt idx="8">
                  <c:v>-6.6265060240963862</c:v>
                </c:pt>
              </c:numCache>
            </c:numRef>
          </c:xVal>
          <c:yVal>
            <c:numRef>
              <c:f>'LDL-C作図'!$AE$15:$AE$23</c:f>
              <c:numCache>
                <c:formatCode>General</c:formatCode>
                <c:ptCount val="9"/>
                <c:pt idx="0">
                  <c:v>-2.9032258064516081</c:v>
                </c:pt>
                <c:pt idx="1">
                  <c:v>15.452361889511595</c:v>
                </c:pt>
                <c:pt idx="2">
                  <c:v>-18.370370370370367</c:v>
                </c:pt>
                <c:pt idx="3">
                  <c:v>29.614873837981403</c:v>
                </c:pt>
                <c:pt idx="4">
                  <c:v>12.861736334405144</c:v>
                </c:pt>
                <c:pt idx="5">
                  <c:v>-2.9411764705882382</c:v>
                </c:pt>
                <c:pt idx="6">
                  <c:v>-6.9116360454943058</c:v>
                </c:pt>
                <c:pt idx="7">
                  <c:v>19.95841995841996</c:v>
                </c:pt>
                <c:pt idx="8">
                  <c:v>-3.31491712707181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169424"/>
        <c:axId val="188169984"/>
      </c:scatterChart>
      <c:valAx>
        <c:axId val="1881694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169984"/>
        <c:crosses val="autoZero"/>
        <c:crossBetween val="midCat"/>
      </c:valAx>
      <c:valAx>
        <c:axId val="18816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1694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A$24:$AA$30</c:f>
              <c:numCache>
                <c:formatCode>General</c:formatCode>
                <c:ptCount val="7"/>
                <c:pt idx="0">
                  <c:v>-60.408163265306122</c:v>
                </c:pt>
                <c:pt idx="1">
                  <c:v>-60.683760683760681</c:v>
                </c:pt>
                <c:pt idx="2">
                  <c:v>-62.711864406779661</c:v>
                </c:pt>
                <c:pt idx="3">
                  <c:v>-50.505050505050505</c:v>
                </c:pt>
                <c:pt idx="4">
                  <c:v>-62.135922330097081</c:v>
                </c:pt>
                <c:pt idx="5">
                  <c:v>-70.404984423676012</c:v>
                </c:pt>
                <c:pt idx="6">
                  <c:v>-52.857142857142861</c:v>
                </c:pt>
              </c:numCache>
            </c:numRef>
          </c:xVal>
          <c:yVal>
            <c:numRef>
              <c:f>'LDL-C作図'!$AB$24:$AB$30</c:f>
              <c:numCache>
                <c:formatCode>General</c:formatCode>
                <c:ptCount val="7"/>
                <c:pt idx="0">
                  <c:v>-19.354838709677413</c:v>
                </c:pt>
                <c:pt idx="1">
                  <c:v>5.6746532156368223</c:v>
                </c:pt>
                <c:pt idx="2">
                  <c:v>-10.471806674338328</c:v>
                </c:pt>
                <c:pt idx="3">
                  <c:v>14.347826086956525</c:v>
                </c:pt>
                <c:pt idx="4">
                  <c:v>-20.143312101910826</c:v>
                </c:pt>
                <c:pt idx="5">
                  <c:v>3.2019704433497465</c:v>
                </c:pt>
                <c:pt idx="6">
                  <c:v>-5.86592178770948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888016"/>
        <c:axId val="190888576"/>
      </c:scatterChart>
      <c:valAx>
        <c:axId val="1908880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88576"/>
        <c:crosses val="autoZero"/>
        <c:crossBetween val="midCat"/>
      </c:valAx>
      <c:valAx>
        <c:axId val="190888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88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V$25:$V$31</c:f>
              <c:numCache>
                <c:formatCode>General</c:formatCode>
                <c:ptCount val="7"/>
                <c:pt idx="0">
                  <c:v>-7.216494845360824</c:v>
                </c:pt>
                <c:pt idx="1">
                  <c:v>-4.3478260869565215</c:v>
                </c:pt>
                <c:pt idx="2">
                  <c:v>1.8181818181818181</c:v>
                </c:pt>
                <c:pt idx="3">
                  <c:v>-15.306122448979592</c:v>
                </c:pt>
                <c:pt idx="4">
                  <c:v>-22.222222222222221</c:v>
                </c:pt>
                <c:pt idx="5">
                  <c:v>2.1052631578947367</c:v>
                </c:pt>
                <c:pt idx="6">
                  <c:v>-7.5757575757575761</c:v>
                </c:pt>
              </c:numCache>
            </c:numRef>
          </c:xVal>
          <c:yVal>
            <c:numRef>
              <c:f>'LDL-C作図'!$W$25:$W$31</c:f>
              <c:numCache>
                <c:formatCode>General</c:formatCode>
                <c:ptCount val="7"/>
                <c:pt idx="0">
                  <c:v>25.161290322580644</c:v>
                </c:pt>
                <c:pt idx="1">
                  <c:v>15.03579952267304</c:v>
                </c:pt>
                <c:pt idx="2">
                  <c:v>5.2699228791773889</c:v>
                </c:pt>
                <c:pt idx="3">
                  <c:v>-4.752851711026616</c:v>
                </c:pt>
                <c:pt idx="4">
                  <c:v>29.611166500498509</c:v>
                </c:pt>
                <c:pt idx="5">
                  <c:v>8.8305489260143268</c:v>
                </c:pt>
                <c:pt idx="6">
                  <c:v>-33.086053412462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890816"/>
        <c:axId val="190891376"/>
      </c:scatterChart>
      <c:valAx>
        <c:axId val="1908908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91376"/>
        <c:crosses val="autoZero"/>
        <c:crossBetween val="midCat"/>
      </c:valAx>
      <c:valAx>
        <c:axId val="19089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908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X$25:$X$31</c:f>
              <c:numCache>
                <c:formatCode>General</c:formatCode>
                <c:ptCount val="7"/>
                <c:pt idx="0">
                  <c:v>-15.555555555555555</c:v>
                </c:pt>
                <c:pt idx="1">
                  <c:v>-3.7878787878787881</c:v>
                </c:pt>
                <c:pt idx="2">
                  <c:v>-6.25</c:v>
                </c:pt>
                <c:pt idx="3">
                  <c:v>-15.66265060240964</c:v>
                </c:pt>
                <c:pt idx="4">
                  <c:v>-4.395604395604396</c:v>
                </c:pt>
                <c:pt idx="5">
                  <c:v>-31.958762886597935</c:v>
                </c:pt>
                <c:pt idx="6">
                  <c:v>-31.967213114754102</c:v>
                </c:pt>
              </c:numCache>
            </c:numRef>
          </c:xVal>
          <c:yVal>
            <c:numRef>
              <c:f>'LDL-C作図'!$Y$25:$Y$31</c:f>
              <c:numCache>
                <c:formatCode>General</c:formatCode>
                <c:ptCount val="7"/>
                <c:pt idx="0">
                  <c:v>-6.1855670103092786</c:v>
                </c:pt>
                <c:pt idx="1">
                  <c:v>-17.01244813278009</c:v>
                </c:pt>
                <c:pt idx="2">
                  <c:v>-8.3028083028083159</c:v>
                </c:pt>
                <c:pt idx="3">
                  <c:v>-23.952095808383234</c:v>
                </c:pt>
                <c:pt idx="4">
                  <c:v>-18.461538461538463</c:v>
                </c:pt>
                <c:pt idx="5">
                  <c:v>-18.201754385964922</c:v>
                </c:pt>
                <c:pt idx="6">
                  <c:v>7.31707317073170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431616"/>
        <c:axId val="191432176"/>
      </c:scatterChart>
      <c:valAx>
        <c:axId val="1914316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432176"/>
        <c:crosses val="autoZero"/>
        <c:crossBetween val="midCat"/>
      </c:valAx>
      <c:valAx>
        <c:axId val="191432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4316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O$33:$O$39</c:f>
              <c:numCache>
                <c:formatCode>General</c:formatCode>
                <c:ptCount val="7"/>
                <c:pt idx="0">
                  <c:v>-33.82352941176471</c:v>
                </c:pt>
                <c:pt idx="1">
                  <c:v>8.9743589743589745</c:v>
                </c:pt>
                <c:pt idx="2">
                  <c:v>-67.567567567567565</c:v>
                </c:pt>
                <c:pt idx="3">
                  <c:v>9.5238095238095237</c:v>
                </c:pt>
                <c:pt idx="4">
                  <c:v>-19.148936170212767</c:v>
                </c:pt>
                <c:pt idx="5">
                  <c:v>-4.395604395604396</c:v>
                </c:pt>
                <c:pt idx="6">
                  <c:v>-33.82352941176471</c:v>
                </c:pt>
              </c:numCache>
            </c:numRef>
          </c:xVal>
          <c:yVal>
            <c:numRef>
              <c:f>TG作図!$P$33:$P$39</c:f>
              <c:numCache>
                <c:formatCode>General</c:formatCode>
                <c:ptCount val="7"/>
                <c:pt idx="0">
                  <c:v>-19.354838709677413</c:v>
                </c:pt>
                <c:pt idx="1">
                  <c:v>5.6746532156368223</c:v>
                </c:pt>
                <c:pt idx="2">
                  <c:v>-10.471806674338328</c:v>
                </c:pt>
                <c:pt idx="3">
                  <c:v>14.347826086956525</c:v>
                </c:pt>
                <c:pt idx="4">
                  <c:v>-20.143312101910826</c:v>
                </c:pt>
                <c:pt idx="5">
                  <c:v>3.2019704433497465</c:v>
                </c:pt>
                <c:pt idx="6">
                  <c:v>-5.86592178770948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033968"/>
        <c:axId val="191034528"/>
      </c:scatterChart>
      <c:valAx>
        <c:axId val="1910339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34528"/>
        <c:crosses val="autoZero"/>
        <c:crossBetween val="midCat"/>
      </c:valAx>
      <c:valAx>
        <c:axId val="191034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339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Q$33:$Q$39</c:f>
              <c:numCache>
                <c:formatCode>General</c:formatCode>
                <c:ptCount val="7"/>
                <c:pt idx="0">
                  <c:v>-6.666666666666667</c:v>
                </c:pt>
                <c:pt idx="1">
                  <c:v>-22.352941176470591</c:v>
                </c:pt>
                <c:pt idx="2">
                  <c:v>43.055555555555557</c:v>
                </c:pt>
                <c:pt idx="3">
                  <c:v>-31.05590062111801</c:v>
                </c:pt>
                <c:pt idx="4">
                  <c:v>26.315789473684209</c:v>
                </c:pt>
                <c:pt idx="5">
                  <c:v>57.47126436781609</c:v>
                </c:pt>
                <c:pt idx="6">
                  <c:v>28.888888888888886</c:v>
                </c:pt>
              </c:numCache>
            </c:numRef>
          </c:xVal>
          <c:yVal>
            <c:numRef>
              <c:f>TG作図!$R$33:$R$39</c:f>
              <c:numCache>
                <c:formatCode>General</c:formatCode>
                <c:ptCount val="7"/>
                <c:pt idx="0">
                  <c:v>25.161290322580644</c:v>
                </c:pt>
                <c:pt idx="1">
                  <c:v>15.03579952267304</c:v>
                </c:pt>
                <c:pt idx="2">
                  <c:v>5.2699228791773889</c:v>
                </c:pt>
                <c:pt idx="3">
                  <c:v>-4.752851711026616</c:v>
                </c:pt>
                <c:pt idx="4">
                  <c:v>29.611166500498509</c:v>
                </c:pt>
                <c:pt idx="5">
                  <c:v>8.8305489260143268</c:v>
                </c:pt>
                <c:pt idx="6">
                  <c:v>-33.086053412462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036768"/>
        <c:axId val="191037328"/>
      </c:scatterChart>
      <c:valAx>
        <c:axId val="1910367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37328"/>
        <c:crosses val="autoZero"/>
        <c:crossBetween val="midCat"/>
      </c:valAx>
      <c:valAx>
        <c:axId val="191037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36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S$33:$S$39</c:f>
              <c:numCache>
                <c:formatCode>General</c:formatCode>
                <c:ptCount val="7"/>
                <c:pt idx="0">
                  <c:v>30.952380952380953</c:v>
                </c:pt>
                <c:pt idx="1">
                  <c:v>18.181818181818183</c:v>
                </c:pt>
                <c:pt idx="2">
                  <c:v>22.330097087378643</c:v>
                </c:pt>
                <c:pt idx="3">
                  <c:v>28.828828828828829</c:v>
                </c:pt>
                <c:pt idx="4">
                  <c:v>-10.416666666666668</c:v>
                </c:pt>
                <c:pt idx="5">
                  <c:v>-21.897810218978105</c:v>
                </c:pt>
                <c:pt idx="6">
                  <c:v>-17.241379310344829</c:v>
                </c:pt>
              </c:numCache>
            </c:numRef>
          </c:xVal>
          <c:yVal>
            <c:numRef>
              <c:f>TG作図!$T$33:$T$39</c:f>
              <c:numCache>
                <c:formatCode>General</c:formatCode>
                <c:ptCount val="7"/>
                <c:pt idx="0">
                  <c:v>-6.1855670103092786</c:v>
                </c:pt>
                <c:pt idx="1">
                  <c:v>-17.01244813278009</c:v>
                </c:pt>
                <c:pt idx="2">
                  <c:v>-8.3028083028083159</c:v>
                </c:pt>
                <c:pt idx="3">
                  <c:v>-23.952095808383234</c:v>
                </c:pt>
                <c:pt idx="4">
                  <c:v>-18.461538461538463</c:v>
                </c:pt>
                <c:pt idx="5">
                  <c:v>-18.201754385964922</c:v>
                </c:pt>
                <c:pt idx="6">
                  <c:v>7.31707317073170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039568"/>
        <c:axId val="191040128"/>
      </c:scatterChart>
      <c:valAx>
        <c:axId val="1910395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40128"/>
        <c:crosses val="autoZero"/>
        <c:crossBetween val="midCat"/>
      </c:valAx>
      <c:valAx>
        <c:axId val="191040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0395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L$33:$L$39</c:f>
              <c:numCache>
                <c:formatCode>General</c:formatCode>
                <c:ptCount val="7"/>
                <c:pt idx="0">
                  <c:v>-46</c:v>
                </c:pt>
                <c:pt idx="1">
                  <c:v>-49.397590361445786</c:v>
                </c:pt>
                <c:pt idx="2">
                  <c:v>-81.045751633986924</c:v>
                </c:pt>
                <c:pt idx="3">
                  <c:v>-34.246575342465754</c:v>
                </c:pt>
                <c:pt idx="4">
                  <c:v>-59.701492537313428</c:v>
                </c:pt>
                <c:pt idx="5">
                  <c:v>-55.405405405405403</c:v>
                </c:pt>
                <c:pt idx="6">
                  <c:v>-57.000000000000007</c:v>
                </c:pt>
              </c:numCache>
            </c:numRef>
          </c:xVal>
          <c:yVal>
            <c:numRef>
              <c:f>'RLP-C作図'!$M$33:$M$39</c:f>
              <c:numCache>
                <c:formatCode>General</c:formatCode>
                <c:ptCount val="7"/>
                <c:pt idx="0">
                  <c:v>-19.354838709677413</c:v>
                </c:pt>
                <c:pt idx="1">
                  <c:v>5.6746532156368223</c:v>
                </c:pt>
                <c:pt idx="2">
                  <c:v>-10.471806674338328</c:v>
                </c:pt>
                <c:pt idx="3">
                  <c:v>14.347826086956525</c:v>
                </c:pt>
                <c:pt idx="4">
                  <c:v>-20.143312101910826</c:v>
                </c:pt>
                <c:pt idx="5">
                  <c:v>3.2019704433497465</c:v>
                </c:pt>
                <c:pt idx="6">
                  <c:v>-5.86592178770948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567168"/>
        <c:axId val="191567728"/>
      </c:scatterChart>
      <c:valAx>
        <c:axId val="1915671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67728"/>
        <c:crosses val="autoZero"/>
        <c:crossBetween val="midCat"/>
      </c:valAx>
      <c:valAx>
        <c:axId val="191567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671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N$33:$N$39</c:f>
              <c:numCache>
                <c:formatCode>General</c:formatCode>
                <c:ptCount val="7"/>
                <c:pt idx="0">
                  <c:v>-25.925925925925931</c:v>
                </c:pt>
                <c:pt idx="1">
                  <c:v>2.3809523809523725</c:v>
                </c:pt>
                <c:pt idx="2">
                  <c:v>34.482758620689658</c:v>
                </c:pt>
                <c:pt idx="3">
                  <c:v>-43.749999999999993</c:v>
                </c:pt>
                <c:pt idx="4">
                  <c:v>-7.4074074074074137</c:v>
                </c:pt>
                <c:pt idx="5">
                  <c:v>27.272727272727288</c:v>
                </c:pt>
                <c:pt idx="6">
                  <c:v>13.953488372093037</c:v>
                </c:pt>
              </c:numCache>
            </c:numRef>
          </c:xVal>
          <c:yVal>
            <c:numRef>
              <c:f>'RLP-C作図'!$O$33:$O$39</c:f>
              <c:numCache>
                <c:formatCode>General</c:formatCode>
                <c:ptCount val="7"/>
                <c:pt idx="0">
                  <c:v>25.161290322580644</c:v>
                </c:pt>
                <c:pt idx="1">
                  <c:v>15.03579952267304</c:v>
                </c:pt>
                <c:pt idx="2">
                  <c:v>5.2699228791773889</c:v>
                </c:pt>
                <c:pt idx="3">
                  <c:v>-4.752851711026616</c:v>
                </c:pt>
                <c:pt idx="4">
                  <c:v>29.611166500498509</c:v>
                </c:pt>
                <c:pt idx="5">
                  <c:v>8.8305489260143268</c:v>
                </c:pt>
                <c:pt idx="6">
                  <c:v>-33.086053412462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569968"/>
        <c:axId val="191570528"/>
      </c:scatterChart>
      <c:valAx>
        <c:axId val="1915699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70528"/>
        <c:crosses val="autoZero"/>
        <c:crossBetween val="midCat"/>
      </c:valAx>
      <c:valAx>
        <c:axId val="191570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699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P$33:$P$39</c:f>
              <c:numCache>
                <c:formatCode>General</c:formatCode>
                <c:ptCount val="7"/>
                <c:pt idx="0">
                  <c:v>0</c:v>
                </c:pt>
                <c:pt idx="1">
                  <c:v>-6.9767441860465071</c:v>
                </c:pt>
                <c:pt idx="2">
                  <c:v>10.256410256410255</c:v>
                </c:pt>
                <c:pt idx="3">
                  <c:v>25.925925925925913</c:v>
                </c:pt>
                <c:pt idx="4">
                  <c:v>-20</c:v>
                </c:pt>
                <c:pt idx="5">
                  <c:v>-30.95238095238096</c:v>
                </c:pt>
                <c:pt idx="6">
                  <c:v>-4.0816326530612272</c:v>
                </c:pt>
              </c:numCache>
            </c:numRef>
          </c:xVal>
          <c:yVal>
            <c:numRef>
              <c:f>'RLP-C作図'!$Q$33:$Q$39</c:f>
              <c:numCache>
                <c:formatCode>General</c:formatCode>
                <c:ptCount val="7"/>
                <c:pt idx="0">
                  <c:v>-6.1855670103092786</c:v>
                </c:pt>
                <c:pt idx="1">
                  <c:v>-17.01244813278009</c:v>
                </c:pt>
                <c:pt idx="2">
                  <c:v>-8.3028083028083159</c:v>
                </c:pt>
                <c:pt idx="3">
                  <c:v>-23.952095808383234</c:v>
                </c:pt>
                <c:pt idx="4">
                  <c:v>-18.461538461538463</c:v>
                </c:pt>
                <c:pt idx="5">
                  <c:v>-18.201754385964922</c:v>
                </c:pt>
                <c:pt idx="6">
                  <c:v>7.31707317073170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572768"/>
        <c:axId val="191573328"/>
      </c:scatterChart>
      <c:valAx>
        <c:axId val="1915727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73328"/>
        <c:crosses val="autoZero"/>
        <c:crossBetween val="midCat"/>
      </c:valAx>
      <c:valAx>
        <c:axId val="191573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1572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F$15:$AF$22</c:f>
              <c:numCache>
                <c:formatCode>General</c:formatCode>
                <c:ptCount val="8"/>
                <c:pt idx="0">
                  <c:v>25.161290322580644</c:v>
                </c:pt>
                <c:pt idx="1">
                  <c:v>15.03579952267304</c:v>
                </c:pt>
                <c:pt idx="2">
                  <c:v>5.2699228791773889</c:v>
                </c:pt>
                <c:pt idx="3">
                  <c:v>-4.752851711026616</c:v>
                </c:pt>
                <c:pt idx="4">
                  <c:v>29.611166500498509</c:v>
                </c:pt>
                <c:pt idx="5">
                  <c:v>8.8305489260143268</c:v>
                </c:pt>
                <c:pt idx="6">
                  <c:v>-33.08605341246291</c:v>
                </c:pt>
              </c:numCache>
            </c:numRef>
          </c:xVal>
          <c:yVal>
            <c:numRef>
              <c:f>'LDL-C作図'!$AG$15:$AG$22</c:f>
              <c:numCache>
                <c:formatCode>General</c:formatCode>
                <c:ptCount val="8"/>
                <c:pt idx="0">
                  <c:v>-6.1855670103092786</c:v>
                </c:pt>
                <c:pt idx="1">
                  <c:v>-17.01244813278009</c:v>
                </c:pt>
                <c:pt idx="2">
                  <c:v>-8.3028083028083159</c:v>
                </c:pt>
                <c:pt idx="3">
                  <c:v>-23.952095808383234</c:v>
                </c:pt>
                <c:pt idx="4">
                  <c:v>-18.461538461538463</c:v>
                </c:pt>
                <c:pt idx="5">
                  <c:v>-18.201754385964922</c:v>
                </c:pt>
                <c:pt idx="6">
                  <c:v>7.31707317073170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135760"/>
        <c:axId val="192136320"/>
      </c:scatterChart>
      <c:valAx>
        <c:axId val="1921357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36320"/>
        <c:crosses val="autoZero"/>
        <c:crossBetween val="midCat"/>
      </c:valAx>
      <c:valAx>
        <c:axId val="192136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357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D$15:$AD$23</c:f>
              <c:numCache>
                <c:formatCode>General</c:formatCode>
                <c:ptCount val="9"/>
                <c:pt idx="0">
                  <c:v>43.137254901960787</c:v>
                </c:pt>
                <c:pt idx="1">
                  <c:v>-12.903225806451612</c:v>
                </c:pt>
                <c:pt idx="2">
                  <c:v>-11.458333333333332</c:v>
                </c:pt>
                <c:pt idx="3">
                  <c:v>-25.714285714285712</c:v>
                </c:pt>
                <c:pt idx="4">
                  <c:v>6.481481481481481</c:v>
                </c:pt>
                <c:pt idx="5">
                  <c:v>-7.1999999999999993</c:v>
                </c:pt>
                <c:pt idx="6">
                  <c:v>1.0752688172043012</c:v>
                </c:pt>
                <c:pt idx="7">
                  <c:v>-27.61904761904762</c:v>
                </c:pt>
                <c:pt idx="8">
                  <c:v>-7.096774193548387</c:v>
                </c:pt>
              </c:numCache>
            </c:numRef>
          </c:xVal>
          <c:yVal>
            <c:numRef>
              <c:f>'LDL-C作図'!$AE$15:$AE$23</c:f>
              <c:numCache>
                <c:formatCode>General</c:formatCode>
                <c:ptCount val="9"/>
                <c:pt idx="0">
                  <c:v>-11.461794019933564</c:v>
                </c:pt>
                <c:pt idx="1">
                  <c:v>-3.5367545076282902</c:v>
                </c:pt>
                <c:pt idx="2">
                  <c:v>13.248638838475493</c:v>
                </c:pt>
                <c:pt idx="3">
                  <c:v>-19.262295081967213</c:v>
                </c:pt>
                <c:pt idx="4">
                  <c:v>6.6951566951566992</c:v>
                </c:pt>
                <c:pt idx="5">
                  <c:v>-3.7878787878787881</c:v>
                </c:pt>
                <c:pt idx="6">
                  <c:v>-5.6390977443609023</c:v>
                </c:pt>
                <c:pt idx="7">
                  <c:v>-23.050259965337961</c:v>
                </c:pt>
                <c:pt idx="8">
                  <c:v>-8.00000000000000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170544"/>
        <c:axId val="188171104"/>
      </c:scatterChart>
      <c:valAx>
        <c:axId val="1881705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171104"/>
        <c:crosses val="autoZero"/>
        <c:crossBetween val="midCat"/>
      </c:valAx>
      <c:valAx>
        <c:axId val="188171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1705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I$15:$AI$22</c:f>
              <c:numCache>
                <c:formatCode>General</c:formatCode>
                <c:ptCount val="8"/>
                <c:pt idx="0">
                  <c:v>54.245283018867937</c:v>
                </c:pt>
                <c:pt idx="1">
                  <c:v>32.308118592407872</c:v>
                </c:pt>
                <c:pt idx="2">
                  <c:v>24.796358409199808</c:v>
                </c:pt>
                <c:pt idx="3">
                  <c:v>3.0517879161529082</c:v>
                </c:pt>
                <c:pt idx="4">
                  <c:v>18.071625344352622</c:v>
                </c:pt>
                <c:pt idx="5">
                  <c:v>19.832402234636877</c:v>
                </c:pt>
                <c:pt idx="6">
                  <c:v>7.9092159559834938</c:v>
                </c:pt>
              </c:numCache>
            </c:numRef>
          </c:xVal>
          <c:yVal>
            <c:numRef>
              <c:f>'LDL-C作図'!$AJ$15:$AJ$22</c:f>
              <c:numCache>
                <c:formatCode>General</c:formatCode>
                <c:ptCount val="8"/>
                <c:pt idx="0">
                  <c:v>44.954128440366951</c:v>
                </c:pt>
                <c:pt idx="1">
                  <c:v>-1.0680628272251356</c:v>
                </c:pt>
                <c:pt idx="2">
                  <c:v>-29.122672297945861</c:v>
                </c:pt>
                <c:pt idx="3">
                  <c:v>32.84475022434939</c:v>
                </c:pt>
                <c:pt idx="4">
                  <c:v>-18.385440970601962</c:v>
                </c:pt>
                <c:pt idx="5">
                  <c:v>-17.082917082917088</c:v>
                </c:pt>
                <c:pt idx="6">
                  <c:v>-9.36902485659656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138560"/>
        <c:axId val="192139120"/>
      </c:scatterChart>
      <c:valAx>
        <c:axId val="1921385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39120"/>
        <c:crosses val="autoZero"/>
        <c:crossBetween val="midCat"/>
      </c:valAx>
      <c:valAx>
        <c:axId val="192139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385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M$3:$AM$11</c:f>
              <c:numCache>
                <c:formatCode>General</c:formatCode>
                <c:ptCount val="9"/>
                <c:pt idx="0">
                  <c:v>43.137254901960787</c:v>
                </c:pt>
                <c:pt idx="1">
                  <c:v>-12.903225806451612</c:v>
                </c:pt>
                <c:pt idx="2">
                  <c:v>-11.458333333333332</c:v>
                </c:pt>
                <c:pt idx="3">
                  <c:v>-25.714285714285712</c:v>
                </c:pt>
                <c:pt idx="4">
                  <c:v>6.481481481481481</c:v>
                </c:pt>
                <c:pt idx="5">
                  <c:v>-7.1999999999999993</c:v>
                </c:pt>
                <c:pt idx="6">
                  <c:v>1.0752688172043012</c:v>
                </c:pt>
                <c:pt idx="7">
                  <c:v>-27.61904761904762</c:v>
                </c:pt>
                <c:pt idx="8">
                  <c:v>-7.096774193548387</c:v>
                </c:pt>
              </c:numCache>
            </c:numRef>
          </c:xVal>
          <c:yVal>
            <c:numRef>
              <c:f>'LDL-C作図'!$AN$3:$AN$11</c:f>
              <c:numCache>
                <c:formatCode>General</c:formatCode>
                <c:ptCount val="9"/>
                <c:pt idx="0">
                  <c:v>4.2987407729048961</c:v>
                </c:pt>
                <c:pt idx="1">
                  <c:v>2.7859856479527201</c:v>
                </c:pt>
                <c:pt idx="2">
                  <c:v>-37.716262975778541</c:v>
                </c:pt>
                <c:pt idx="3">
                  <c:v>-7.4855252274607214</c:v>
                </c:pt>
                <c:pt idx="4">
                  <c:v>36.561264822134369</c:v>
                </c:pt>
                <c:pt idx="5">
                  <c:v>-42.465408805031451</c:v>
                </c:pt>
                <c:pt idx="6">
                  <c:v>25.450549450549442</c:v>
                </c:pt>
                <c:pt idx="7">
                  <c:v>80.794701986754973</c:v>
                </c:pt>
                <c:pt idx="8">
                  <c:v>-68.7191307211063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141360"/>
        <c:axId val="192141920"/>
      </c:scatterChart>
      <c:valAx>
        <c:axId val="1921413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41920"/>
        <c:crosses val="autoZero"/>
        <c:crossBetween val="midCat"/>
      </c:valAx>
      <c:valAx>
        <c:axId val="1921419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1413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V$23:$V$31</c:f>
              <c:numCache>
                <c:formatCode>General</c:formatCode>
                <c:ptCount val="9"/>
                <c:pt idx="0">
                  <c:v>-35.454545454545453</c:v>
                </c:pt>
                <c:pt idx="1">
                  <c:v>25.274725274725274</c:v>
                </c:pt>
                <c:pt idx="2">
                  <c:v>-30.708661417322837</c:v>
                </c:pt>
                <c:pt idx="3">
                  <c:v>0</c:v>
                </c:pt>
                <c:pt idx="4">
                  <c:v>-34.523809523809526</c:v>
                </c:pt>
                <c:pt idx="5">
                  <c:v>-29.545454545454547</c:v>
                </c:pt>
                <c:pt idx="6">
                  <c:v>-23.157894736842106</c:v>
                </c:pt>
                <c:pt idx="7">
                  <c:v>-26.190476190476193</c:v>
                </c:pt>
                <c:pt idx="8">
                  <c:v>-61.570247933884289</c:v>
                </c:pt>
              </c:numCache>
            </c:numRef>
          </c:xVal>
          <c:yVal>
            <c:numRef>
              <c:f>TG作図!$W$23:$W$31</c:f>
              <c:numCache>
                <c:formatCode>General</c:formatCode>
                <c:ptCount val="9"/>
                <c:pt idx="0">
                  <c:v>4.0153631284916207</c:v>
                </c:pt>
                <c:pt idx="1">
                  <c:v>68.09492419248518</c:v>
                </c:pt>
                <c:pt idx="2">
                  <c:v>24.568434032059201</c:v>
                </c:pt>
                <c:pt idx="3">
                  <c:v>9.5031355523395984</c:v>
                </c:pt>
                <c:pt idx="4">
                  <c:v>146.93548387096774</c:v>
                </c:pt>
                <c:pt idx="5">
                  <c:v>-2.7224435590969418</c:v>
                </c:pt>
                <c:pt idx="6">
                  <c:v>-7.7116212338593977</c:v>
                </c:pt>
                <c:pt idx="7">
                  <c:v>2.8749567024593041</c:v>
                </c:pt>
                <c:pt idx="8">
                  <c:v>78.08676307007785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713984"/>
        <c:axId val="192714544"/>
      </c:scatterChart>
      <c:valAx>
        <c:axId val="1927139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714544"/>
        <c:crosses val="autoZero"/>
        <c:crossBetween val="midCat"/>
      </c:valAx>
      <c:valAx>
        <c:axId val="192714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7139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X$23:$X$31</c:f>
              <c:numCache>
                <c:formatCode>General</c:formatCode>
                <c:ptCount val="9"/>
                <c:pt idx="0">
                  <c:v>26.760563380281688</c:v>
                </c:pt>
                <c:pt idx="1">
                  <c:v>-29.82456140350877</c:v>
                </c:pt>
                <c:pt idx="2">
                  <c:v>19.318181818181817</c:v>
                </c:pt>
                <c:pt idx="3">
                  <c:v>-19.753086419753085</c:v>
                </c:pt>
                <c:pt idx="4">
                  <c:v>36.363636363636367</c:v>
                </c:pt>
                <c:pt idx="5">
                  <c:v>16.129032258064516</c:v>
                </c:pt>
                <c:pt idx="6">
                  <c:v>-10.95890410958904</c:v>
                </c:pt>
                <c:pt idx="7">
                  <c:v>-11.827956989247312</c:v>
                </c:pt>
                <c:pt idx="8">
                  <c:v>5.376344086021505</c:v>
                </c:pt>
              </c:numCache>
            </c:numRef>
          </c:xVal>
          <c:yVal>
            <c:numRef>
              <c:f>TG作図!$Y$23:$Y$31</c:f>
              <c:numCache>
                <c:formatCode>General</c:formatCode>
                <c:ptCount val="9"/>
                <c:pt idx="0">
                  <c:v>-22.692178583417245</c:v>
                </c:pt>
                <c:pt idx="1">
                  <c:v>-7.0980392156862724</c:v>
                </c:pt>
                <c:pt idx="2">
                  <c:v>14.42712199950506</c:v>
                </c:pt>
                <c:pt idx="3">
                  <c:v>6.51982378854626</c:v>
                </c:pt>
                <c:pt idx="4">
                  <c:v>-33.899412148922266</c:v>
                </c:pt>
                <c:pt idx="5">
                  <c:v>35.665529010238906</c:v>
                </c:pt>
                <c:pt idx="6">
                  <c:v>-11.581811115429463</c:v>
                </c:pt>
                <c:pt idx="7">
                  <c:v>1.6835016835016834</c:v>
                </c:pt>
                <c:pt idx="8">
                  <c:v>-5.15302935665209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716784"/>
        <c:axId val="192717344"/>
      </c:scatterChart>
      <c:valAx>
        <c:axId val="1927167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717344"/>
        <c:crosses val="autoZero"/>
        <c:crossBetween val="midCat"/>
      </c:valAx>
      <c:valAx>
        <c:axId val="1927173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7167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Z$23:$Z$31</c:f>
              <c:numCache>
                <c:formatCode>General</c:formatCode>
                <c:ptCount val="9"/>
                <c:pt idx="0">
                  <c:v>92.222222222222229</c:v>
                </c:pt>
                <c:pt idx="1">
                  <c:v>2.5</c:v>
                </c:pt>
                <c:pt idx="2">
                  <c:v>3.8095238095238098</c:v>
                </c:pt>
                <c:pt idx="3">
                  <c:v>23.076923076923077</c:v>
                </c:pt>
                <c:pt idx="4">
                  <c:v>-14.666666666666666</c:v>
                </c:pt>
                <c:pt idx="5">
                  <c:v>8.3333333333333321</c:v>
                </c:pt>
                <c:pt idx="6">
                  <c:v>32.307692307692307</c:v>
                </c:pt>
                <c:pt idx="7">
                  <c:v>-1.2195121951219512</c:v>
                </c:pt>
                <c:pt idx="8">
                  <c:v>37.755102040816325</c:v>
                </c:pt>
              </c:numCache>
            </c:numRef>
          </c:xVal>
          <c:yVal>
            <c:numRef>
              <c:f>TG作図!$AA$23:$AA$31</c:f>
              <c:numCache>
                <c:formatCode>General</c:formatCode>
                <c:ptCount val="9"/>
                <c:pt idx="0">
                  <c:v>4.2987407729048961</c:v>
                </c:pt>
                <c:pt idx="1">
                  <c:v>2.7859856479527201</c:v>
                </c:pt>
                <c:pt idx="2">
                  <c:v>-37.716262975778541</c:v>
                </c:pt>
                <c:pt idx="3">
                  <c:v>-7.4855252274607214</c:v>
                </c:pt>
                <c:pt idx="4">
                  <c:v>36.561264822134369</c:v>
                </c:pt>
                <c:pt idx="5">
                  <c:v>-42.465408805031451</c:v>
                </c:pt>
                <c:pt idx="6">
                  <c:v>25.450549450549442</c:v>
                </c:pt>
                <c:pt idx="7">
                  <c:v>80.794701986754973</c:v>
                </c:pt>
                <c:pt idx="8">
                  <c:v>-68.7191307211063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719584"/>
        <c:axId val="193072208"/>
      </c:scatterChart>
      <c:valAx>
        <c:axId val="1927195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072208"/>
        <c:crosses val="autoZero"/>
        <c:crossBetween val="midCat"/>
      </c:valAx>
      <c:valAx>
        <c:axId val="1930722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27195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S$23:$S$31</c:f>
              <c:numCache>
                <c:formatCode>General</c:formatCode>
                <c:ptCount val="9"/>
                <c:pt idx="0">
                  <c:v>-46.739130434782602</c:v>
                </c:pt>
                <c:pt idx="1">
                  <c:v>-32.258064516129039</c:v>
                </c:pt>
                <c:pt idx="2">
                  <c:v>-55.882352941176471</c:v>
                </c:pt>
                <c:pt idx="3">
                  <c:v>-55.072463768115945</c:v>
                </c:pt>
                <c:pt idx="4">
                  <c:v>-45</c:v>
                </c:pt>
                <c:pt idx="5">
                  <c:v>-44.44444444444445</c:v>
                </c:pt>
                <c:pt idx="6">
                  <c:v>-50.632911392405056</c:v>
                </c:pt>
                <c:pt idx="7">
                  <c:v>-47.222222222222229</c:v>
                </c:pt>
                <c:pt idx="8">
                  <c:v>-79.428571428571431</c:v>
                </c:pt>
              </c:numCache>
            </c:numRef>
          </c:xVal>
          <c:yVal>
            <c:numRef>
              <c:f>'RLP-C作図'!$T$23:$T$31</c:f>
              <c:numCache>
                <c:formatCode>General</c:formatCode>
                <c:ptCount val="9"/>
                <c:pt idx="0">
                  <c:v>4.0153631284916207</c:v>
                </c:pt>
                <c:pt idx="1">
                  <c:v>68.09492419248518</c:v>
                </c:pt>
                <c:pt idx="2">
                  <c:v>24.568434032059201</c:v>
                </c:pt>
                <c:pt idx="3">
                  <c:v>9.5031355523395984</c:v>
                </c:pt>
                <c:pt idx="4">
                  <c:v>146.93548387096774</c:v>
                </c:pt>
                <c:pt idx="5">
                  <c:v>-2.7224435590969418</c:v>
                </c:pt>
                <c:pt idx="6">
                  <c:v>-7.7116212338593977</c:v>
                </c:pt>
                <c:pt idx="7">
                  <c:v>2.8749567024593041</c:v>
                </c:pt>
                <c:pt idx="8">
                  <c:v>78.08676307007785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074448"/>
        <c:axId val="193075008"/>
      </c:scatterChart>
      <c:valAx>
        <c:axId val="1930744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075008"/>
        <c:crosses val="autoZero"/>
        <c:crossBetween val="midCat"/>
      </c:valAx>
      <c:valAx>
        <c:axId val="193075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0744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U$23:$U$31</c:f>
              <c:numCache>
                <c:formatCode>General</c:formatCode>
                <c:ptCount val="9"/>
                <c:pt idx="0">
                  <c:v>-20.408163265306133</c:v>
                </c:pt>
                <c:pt idx="1">
                  <c:v>-46.031746031746032</c:v>
                </c:pt>
                <c:pt idx="2">
                  <c:v>3.3333333333333361</c:v>
                </c:pt>
                <c:pt idx="3">
                  <c:v>-3.2258064516129057</c:v>
                </c:pt>
                <c:pt idx="4">
                  <c:v>-27.27272727272727</c:v>
                </c:pt>
                <c:pt idx="5">
                  <c:v>2.4999999999999911</c:v>
                </c:pt>
                <c:pt idx="6">
                  <c:v>-23.076923076923077</c:v>
                </c:pt>
                <c:pt idx="7">
                  <c:v>-31.578947368421044</c:v>
                </c:pt>
                <c:pt idx="8">
                  <c:v>5.5555555555555483</c:v>
                </c:pt>
              </c:numCache>
            </c:numRef>
          </c:xVal>
          <c:yVal>
            <c:numRef>
              <c:f>'RLP-C作図'!$V$23:$V$31</c:f>
              <c:numCache>
                <c:formatCode>General</c:formatCode>
                <c:ptCount val="9"/>
                <c:pt idx="0">
                  <c:v>-22.692178583417245</c:v>
                </c:pt>
                <c:pt idx="1">
                  <c:v>-7.0980392156862724</c:v>
                </c:pt>
                <c:pt idx="2">
                  <c:v>14.42712199950506</c:v>
                </c:pt>
                <c:pt idx="3">
                  <c:v>6.51982378854626</c:v>
                </c:pt>
                <c:pt idx="4">
                  <c:v>-33.899412148922266</c:v>
                </c:pt>
                <c:pt idx="5">
                  <c:v>35.665529010238906</c:v>
                </c:pt>
                <c:pt idx="6">
                  <c:v>-11.581811115429463</c:v>
                </c:pt>
                <c:pt idx="7">
                  <c:v>1.6835016835016834</c:v>
                </c:pt>
                <c:pt idx="8">
                  <c:v>-5.15302935665209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077248"/>
        <c:axId val="193077808"/>
      </c:scatterChart>
      <c:valAx>
        <c:axId val="1930772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077808"/>
        <c:crosses val="autoZero"/>
        <c:crossBetween val="midCat"/>
      </c:valAx>
      <c:valAx>
        <c:axId val="193077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077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W$23:$W$31</c:f>
              <c:numCache>
                <c:formatCode>General</c:formatCode>
                <c:ptCount val="9"/>
                <c:pt idx="0">
                  <c:v>82.051282051282044</c:v>
                </c:pt>
                <c:pt idx="1">
                  <c:v>44.117647058823543</c:v>
                </c:pt>
                <c:pt idx="2">
                  <c:v>-100</c:v>
                </c:pt>
                <c:pt idx="3">
                  <c:v>-9.9999999999999929</c:v>
                </c:pt>
                <c:pt idx="4">
                  <c:v>37.5</c:v>
                </c:pt>
                <c:pt idx="5">
                  <c:v>36.585365853658544</c:v>
                </c:pt>
                <c:pt idx="6">
                  <c:v>30</c:v>
                </c:pt>
                <c:pt idx="7">
                  <c:v>-23.076923076923077</c:v>
                </c:pt>
                <c:pt idx="8">
                  <c:v>23.684210526315798</c:v>
                </c:pt>
              </c:numCache>
            </c:numRef>
          </c:xVal>
          <c:yVal>
            <c:numRef>
              <c:f>'RLP-C作図'!$X$23:$X$31</c:f>
              <c:numCache>
                <c:formatCode>General</c:formatCode>
                <c:ptCount val="9"/>
                <c:pt idx="0">
                  <c:v>4.2987407729048961</c:v>
                </c:pt>
                <c:pt idx="1">
                  <c:v>2.7859856479527201</c:v>
                </c:pt>
                <c:pt idx="2">
                  <c:v>-37.716262975778541</c:v>
                </c:pt>
                <c:pt idx="3">
                  <c:v>-7.4855252274607214</c:v>
                </c:pt>
                <c:pt idx="4">
                  <c:v>36.561264822134369</c:v>
                </c:pt>
                <c:pt idx="5">
                  <c:v>-42.465408805031451</c:v>
                </c:pt>
                <c:pt idx="6">
                  <c:v>25.450549450549442</c:v>
                </c:pt>
                <c:pt idx="7">
                  <c:v>80.794701986754973</c:v>
                </c:pt>
                <c:pt idx="8">
                  <c:v>-68.7191307211063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356928"/>
        <c:axId val="193357488"/>
      </c:scatterChart>
      <c:valAx>
        <c:axId val="1933569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57488"/>
        <c:crosses val="autoZero"/>
        <c:crossBetween val="midCat"/>
      </c:valAx>
      <c:valAx>
        <c:axId val="193357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569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A$23:$AA$29</c:f>
              <c:numCache>
                <c:formatCode>General</c:formatCode>
                <c:ptCount val="7"/>
                <c:pt idx="0">
                  <c:v>-60.408163265306122</c:v>
                </c:pt>
                <c:pt idx="1">
                  <c:v>-60.683760683760681</c:v>
                </c:pt>
                <c:pt idx="2">
                  <c:v>-62.711864406779661</c:v>
                </c:pt>
                <c:pt idx="3">
                  <c:v>-50.505050505050505</c:v>
                </c:pt>
                <c:pt idx="4">
                  <c:v>-62.135922330097081</c:v>
                </c:pt>
                <c:pt idx="5">
                  <c:v>-70.404984423676012</c:v>
                </c:pt>
                <c:pt idx="6">
                  <c:v>-52.857142857142861</c:v>
                </c:pt>
              </c:numCache>
            </c:numRef>
          </c:xVal>
          <c:yVal>
            <c:numRef>
              <c:f>'LDL-C作図'!$AB$23:$AB$29</c:f>
              <c:numCache>
                <c:formatCode>General</c:formatCode>
                <c:ptCount val="7"/>
                <c:pt idx="0">
                  <c:v>54.245283018867937</c:v>
                </c:pt>
                <c:pt idx="1">
                  <c:v>32.308118592407872</c:v>
                </c:pt>
                <c:pt idx="2">
                  <c:v>24.796358409199808</c:v>
                </c:pt>
                <c:pt idx="3">
                  <c:v>3.0517879161529082</c:v>
                </c:pt>
                <c:pt idx="4">
                  <c:v>18.071625344352622</c:v>
                </c:pt>
                <c:pt idx="5">
                  <c:v>19.832402234636877</c:v>
                </c:pt>
                <c:pt idx="6">
                  <c:v>7.90921595598349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359728"/>
        <c:axId val="193360288"/>
      </c:scatterChart>
      <c:valAx>
        <c:axId val="1933597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60288"/>
        <c:crosses val="autoZero"/>
        <c:crossBetween val="midCat"/>
      </c:valAx>
      <c:valAx>
        <c:axId val="193360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597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E$24:$AE$30</c:f>
              <c:numCache>
                <c:formatCode>General</c:formatCode>
                <c:ptCount val="7"/>
                <c:pt idx="0">
                  <c:v>-7.216494845360824</c:v>
                </c:pt>
                <c:pt idx="1">
                  <c:v>-4.3478260869565215</c:v>
                </c:pt>
                <c:pt idx="2">
                  <c:v>1.8181818181818181</c:v>
                </c:pt>
                <c:pt idx="3">
                  <c:v>-15.306122448979592</c:v>
                </c:pt>
                <c:pt idx="4">
                  <c:v>-22.222222222222221</c:v>
                </c:pt>
                <c:pt idx="5">
                  <c:v>2.1052631578947367</c:v>
                </c:pt>
                <c:pt idx="6">
                  <c:v>-7.5757575757575761</c:v>
                </c:pt>
              </c:numCache>
            </c:numRef>
          </c:xVal>
          <c:yVal>
            <c:numRef>
              <c:f>'LDL-C作図'!$AF$24:$AF$30</c:f>
              <c:numCache>
                <c:formatCode>General</c:formatCode>
                <c:ptCount val="7"/>
                <c:pt idx="0">
                  <c:v>44.954128440366951</c:v>
                </c:pt>
                <c:pt idx="1">
                  <c:v>-1.0680628272251356</c:v>
                </c:pt>
                <c:pt idx="2">
                  <c:v>-29.122672297945861</c:v>
                </c:pt>
                <c:pt idx="3">
                  <c:v>32.84475022434939</c:v>
                </c:pt>
                <c:pt idx="4">
                  <c:v>-18.385440970601962</c:v>
                </c:pt>
                <c:pt idx="5">
                  <c:v>-17.082917082917088</c:v>
                </c:pt>
                <c:pt idx="6">
                  <c:v>-9.36902485659656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362528"/>
        <c:axId val="193363088"/>
      </c:scatterChart>
      <c:valAx>
        <c:axId val="1933625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63088"/>
        <c:crosses val="autoZero"/>
        <c:crossBetween val="midCat"/>
      </c:valAx>
      <c:valAx>
        <c:axId val="193363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33625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E$14:$AE$21</c:f>
              <c:numCache>
                <c:formatCode>General</c:formatCode>
                <c:ptCount val="8"/>
                <c:pt idx="1">
                  <c:v>-19.354838709677413</c:v>
                </c:pt>
                <c:pt idx="2">
                  <c:v>5.6746532156368223</c:v>
                </c:pt>
                <c:pt idx="3">
                  <c:v>-10.471806674338328</c:v>
                </c:pt>
                <c:pt idx="4">
                  <c:v>14.347826086956525</c:v>
                </c:pt>
                <c:pt idx="5">
                  <c:v>-20.143312101910826</c:v>
                </c:pt>
                <c:pt idx="6">
                  <c:v>3.2019704433497465</c:v>
                </c:pt>
                <c:pt idx="7">
                  <c:v>-5.8659217877094818</c:v>
                </c:pt>
              </c:numCache>
            </c:numRef>
          </c:xVal>
          <c:yVal>
            <c:numRef>
              <c:f>'LDL-C作図'!$AF$14:$AF$21</c:f>
              <c:numCache>
                <c:formatCode>General</c:formatCode>
                <c:ptCount val="8"/>
                <c:pt idx="1">
                  <c:v>25.161290322580644</c:v>
                </c:pt>
                <c:pt idx="2">
                  <c:v>15.03579952267304</c:v>
                </c:pt>
                <c:pt idx="3">
                  <c:v>5.2699228791773889</c:v>
                </c:pt>
                <c:pt idx="4">
                  <c:v>-4.752851711026616</c:v>
                </c:pt>
                <c:pt idx="5">
                  <c:v>29.611166500498509</c:v>
                </c:pt>
                <c:pt idx="6">
                  <c:v>8.8305489260143268</c:v>
                </c:pt>
                <c:pt idx="7">
                  <c:v>-33.086053412462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173344"/>
        <c:axId val="46151376"/>
      </c:scatterChart>
      <c:valAx>
        <c:axId val="1881733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151376"/>
        <c:crosses val="autoZero"/>
        <c:crossBetween val="midCat"/>
      </c:valAx>
      <c:valAx>
        <c:axId val="4615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1733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LDL-C作図'!$AI$24:$AI$30</c:f>
              <c:numCache>
                <c:formatCode>General</c:formatCode>
                <c:ptCount val="7"/>
                <c:pt idx="0">
                  <c:v>-15.555555555555555</c:v>
                </c:pt>
                <c:pt idx="1">
                  <c:v>-3.7878787878787881</c:v>
                </c:pt>
                <c:pt idx="2">
                  <c:v>-6.25</c:v>
                </c:pt>
                <c:pt idx="3">
                  <c:v>-15.66265060240964</c:v>
                </c:pt>
                <c:pt idx="4">
                  <c:v>-4.395604395604396</c:v>
                </c:pt>
                <c:pt idx="5">
                  <c:v>-31.958762886597935</c:v>
                </c:pt>
                <c:pt idx="6">
                  <c:v>-31.967213114754102</c:v>
                </c:pt>
              </c:numCache>
            </c:numRef>
          </c:xVal>
          <c:yVal>
            <c:numRef>
              <c:f>'LDL-C作図'!$AJ$24:$AJ$30</c:f>
              <c:numCache>
                <c:formatCode>General</c:formatCode>
                <c:ptCount val="7"/>
                <c:pt idx="0">
                  <c:v>-14.451476793248949</c:v>
                </c:pt>
                <c:pt idx="1">
                  <c:v>33.34038950042337</c:v>
                </c:pt>
                <c:pt idx="2">
                  <c:v>-19.745395449620794</c:v>
                </c:pt>
                <c:pt idx="3">
                  <c:v>-6.0121594235532632</c:v>
                </c:pt>
                <c:pt idx="4">
                  <c:v>9.3767867352773031</c:v>
                </c:pt>
                <c:pt idx="5">
                  <c:v>9.2771084337349485</c:v>
                </c:pt>
                <c:pt idx="6">
                  <c:v>31.0829817158931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718256"/>
        <c:axId val="190718816"/>
      </c:scatterChart>
      <c:valAx>
        <c:axId val="1907182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18816"/>
        <c:crosses val="autoZero"/>
        <c:crossBetween val="midCat"/>
      </c:valAx>
      <c:valAx>
        <c:axId val="190718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182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V$33:$V$39</c:f>
              <c:numCache>
                <c:formatCode>General</c:formatCode>
                <c:ptCount val="7"/>
                <c:pt idx="0">
                  <c:v>-33.82352941176471</c:v>
                </c:pt>
                <c:pt idx="1">
                  <c:v>8.9743589743589745</c:v>
                </c:pt>
                <c:pt idx="2">
                  <c:v>-67.567567567567565</c:v>
                </c:pt>
                <c:pt idx="3">
                  <c:v>9.5238095238095237</c:v>
                </c:pt>
                <c:pt idx="4">
                  <c:v>-19.148936170212767</c:v>
                </c:pt>
                <c:pt idx="5">
                  <c:v>-4.395604395604396</c:v>
                </c:pt>
                <c:pt idx="6">
                  <c:v>-33.82352941176471</c:v>
                </c:pt>
              </c:numCache>
            </c:numRef>
          </c:xVal>
          <c:yVal>
            <c:numRef>
              <c:f>TG作図!$W$33:$W$39</c:f>
              <c:numCache>
                <c:formatCode>General</c:formatCode>
                <c:ptCount val="7"/>
                <c:pt idx="0">
                  <c:v>54.245283018867937</c:v>
                </c:pt>
                <c:pt idx="1">
                  <c:v>32.308118592407872</c:v>
                </c:pt>
                <c:pt idx="2">
                  <c:v>24.796358409199808</c:v>
                </c:pt>
                <c:pt idx="3">
                  <c:v>3.0517879161529082</c:v>
                </c:pt>
                <c:pt idx="4">
                  <c:v>18.071625344352622</c:v>
                </c:pt>
                <c:pt idx="5">
                  <c:v>19.832402234636877</c:v>
                </c:pt>
                <c:pt idx="6">
                  <c:v>7.90921595598349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721056"/>
        <c:axId val="190721616"/>
      </c:scatterChart>
      <c:valAx>
        <c:axId val="1907210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21616"/>
        <c:crosses val="autoZero"/>
        <c:crossBetween val="midCat"/>
      </c:valAx>
      <c:valAx>
        <c:axId val="190721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210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6542888888888888"/>
                  <c:y val="-0.5736961111111110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4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TG作図!$X$33:$X$39</c:f>
              <c:numCache>
                <c:formatCode>General</c:formatCode>
                <c:ptCount val="7"/>
                <c:pt idx="0">
                  <c:v>-6.666666666666667</c:v>
                </c:pt>
                <c:pt idx="1">
                  <c:v>-22.352941176470591</c:v>
                </c:pt>
                <c:pt idx="2">
                  <c:v>43.055555555555557</c:v>
                </c:pt>
                <c:pt idx="3">
                  <c:v>-31.05590062111801</c:v>
                </c:pt>
                <c:pt idx="4">
                  <c:v>26.315789473684209</c:v>
                </c:pt>
                <c:pt idx="5">
                  <c:v>57.47126436781609</c:v>
                </c:pt>
                <c:pt idx="6">
                  <c:v>28.888888888888886</c:v>
                </c:pt>
              </c:numCache>
            </c:numRef>
          </c:xVal>
          <c:yVal>
            <c:numRef>
              <c:f>TG作図!$Y$33:$Y$39</c:f>
              <c:numCache>
                <c:formatCode>General</c:formatCode>
                <c:ptCount val="7"/>
                <c:pt idx="0">
                  <c:v>44.954128440366951</c:v>
                </c:pt>
                <c:pt idx="1">
                  <c:v>-1.0680628272251356</c:v>
                </c:pt>
                <c:pt idx="2">
                  <c:v>-29.122672297945861</c:v>
                </c:pt>
                <c:pt idx="3">
                  <c:v>32.84475022434939</c:v>
                </c:pt>
                <c:pt idx="4">
                  <c:v>-18.385440970601962</c:v>
                </c:pt>
                <c:pt idx="5">
                  <c:v>-17.082917082917088</c:v>
                </c:pt>
                <c:pt idx="6">
                  <c:v>-9.36902485659656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723856"/>
        <c:axId val="190724416"/>
      </c:scatterChart>
      <c:valAx>
        <c:axId val="1907238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24416"/>
        <c:crosses val="autoZero"/>
        <c:crossBetween val="midCat"/>
      </c:valAx>
      <c:valAx>
        <c:axId val="1907244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7238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Z$33:$Z$39</c:f>
              <c:numCache>
                <c:formatCode>General</c:formatCode>
                <c:ptCount val="7"/>
                <c:pt idx="0">
                  <c:v>30.952380952380953</c:v>
                </c:pt>
                <c:pt idx="1">
                  <c:v>18.181818181818183</c:v>
                </c:pt>
                <c:pt idx="2">
                  <c:v>22.330097087378643</c:v>
                </c:pt>
                <c:pt idx="3">
                  <c:v>28.828828828828829</c:v>
                </c:pt>
                <c:pt idx="4">
                  <c:v>-10.416666666666668</c:v>
                </c:pt>
                <c:pt idx="5">
                  <c:v>-21.897810218978105</c:v>
                </c:pt>
                <c:pt idx="6">
                  <c:v>-17.241379310344829</c:v>
                </c:pt>
              </c:numCache>
            </c:numRef>
          </c:xVal>
          <c:yVal>
            <c:numRef>
              <c:f>TG作図!$AA$33:$AA$39</c:f>
              <c:numCache>
                <c:formatCode>General</c:formatCode>
                <c:ptCount val="7"/>
                <c:pt idx="0">
                  <c:v>-14.451476793248949</c:v>
                </c:pt>
                <c:pt idx="1">
                  <c:v>33.34038950042337</c:v>
                </c:pt>
                <c:pt idx="2">
                  <c:v>-19.745395449620794</c:v>
                </c:pt>
                <c:pt idx="3">
                  <c:v>-6.0121594235532632</c:v>
                </c:pt>
                <c:pt idx="4">
                  <c:v>9.3767867352773031</c:v>
                </c:pt>
                <c:pt idx="5">
                  <c:v>9.2771084337349485</c:v>
                </c:pt>
                <c:pt idx="6">
                  <c:v>31.0829817158931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05392"/>
        <c:axId val="194605952"/>
      </c:scatterChart>
      <c:valAx>
        <c:axId val="1946053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05952"/>
        <c:crosses val="autoZero"/>
        <c:crossBetween val="midCat"/>
      </c:valAx>
      <c:valAx>
        <c:axId val="1946059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053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S$33:$S$39</c:f>
              <c:numCache>
                <c:formatCode>General</c:formatCode>
                <c:ptCount val="7"/>
                <c:pt idx="0">
                  <c:v>-46</c:v>
                </c:pt>
                <c:pt idx="1">
                  <c:v>-49.397590361445786</c:v>
                </c:pt>
                <c:pt idx="2">
                  <c:v>-81.045751633986924</c:v>
                </c:pt>
                <c:pt idx="3">
                  <c:v>-34.246575342465754</c:v>
                </c:pt>
                <c:pt idx="4">
                  <c:v>-59.701492537313428</c:v>
                </c:pt>
                <c:pt idx="5">
                  <c:v>-55.405405405405403</c:v>
                </c:pt>
                <c:pt idx="6">
                  <c:v>-57.000000000000007</c:v>
                </c:pt>
              </c:numCache>
            </c:numRef>
          </c:xVal>
          <c:yVal>
            <c:numRef>
              <c:f>'RLP-C作図'!$T$33:$T$39</c:f>
              <c:numCache>
                <c:formatCode>General</c:formatCode>
                <c:ptCount val="7"/>
                <c:pt idx="0">
                  <c:v>54.245283018867937</c:v>
                </c:pt>
                <c:pt idx="1">
                  <c:v>32.308118592407872</c:v>
                </c:pt>
                <c:pt idx="2">
                  <c:v>24.796358409199808</c:v>
                </c:pt>
                <c:pt idx="3">
                  <c:v>3.0517879161529082</c:v>
                </c:pt>
                <c:pt idx="4">
                  <c:v>18.071625344352622</c:v>
                </c:pt>
                <c:pt idx="5">
                  <c:v>19.832402234636877</c:v>
                </c:pt>
                <c:pt idx="6">
                  <c:v>7.90921595598349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08192"/>
        <c:axId val="194608752"/>
      </c:scatterChart>
      <c:valAx>
        <c:axId val="1946081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08752"/>
        <c:crosses val="autoZero"/>
        <c:crossBetween val="midCat"/>
      </c:valAx>
      <c:valAx>
        <c:axId val="1946087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08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5869027777777778"/>
                  <c:y val="-0.4714844444444444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4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RLP-C作図'!$U$33:$U$39</c:f>
              <c:numCache>
                <c:formatCode>General</c:formatCode>
                <c:ptCount val="7"/>
                <c:pt idx="0">
                  <c:v>-25.925925925925931</c:v>
                </c:pt>
                <c:pt idx="1">
                  <c:v>2.3809523809523725</c:v>
                </c:pt>
                <c:pt idx="2">
                  <c:v>34.482758620689658</c:v>
                </c:pt>
                <c:pt idx="3">
                  <c:v>-43.749999999999993</c:v>
                </c:pt>
                <c:pt idx="4">
                  <c:v>-7.4074074074074137</c:v>
                </c:pt>
                <c:pt idx="5">
                  <c:v>27.272727272727288</c:v>
                </c:pt>
                <c:pt idx="6">
                  <c:v>13.953488372093037</c:v>
                </c:pt>
              </c:numCache>
            </c:numRef>
          </c:xVal>
          <c:yVal>
            <c:numRef>
              <c:f>'RLP-C作図'!$V$33:$V$39</c:f>
              <c:numCache>
                <c:formatCode>General</c:formatCode>
                <c:ptCount val="7"/>
                <c:pt idx="0">
                  <c:v>44.954128440366951</c:v>
                </c:pt>
                <c:pt idx="1">
                  <c:v>-1.0680628272251356</c:v>
                </c:pt>
                <c:pt idx="2">
                  <c:v>-29.122672297945861</c:v>
                </c:pt>
                <c:pt idx="3">
                  <c:v>32.84475022434939</c:v>
                </c:pt>
                <c:pt idx="4">
                  <c:v>-18.385440970601962</c:v>
                </c:pt>
                <c:pt idx="5">
                  <c:v>-17.082917082917088</c:v>
                </c:pt>
                <c:pt idx="6">
                  <c:v>-9.36902485659656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610992"/>
        <c:axId val="194611552"/>
      </c:scatterChart>
      <c:valAx>
        <c:axId val="1946109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11552"/>
        <c:crosses val="autoZero"/>
        <c:crossBetween val="midCat"/>
      </c:valAx>
      <c:valAx>
        <c:axId val="194611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4610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W$33:$W$39</c:f>
              <c:numCache>
                <c:formatCode>General</c:formatCode>
                <c:ptCount val="7"/>
                <c:pt idx="0">
                  <c:v>0</c:v>
                </c:pt>
                <c:pt idx="1">
                  <c:v>-6.9767441860465071</c:v>
                </c:pt>
                <c:pt idx="2">
                  <c:v>10.256410256410255</c:v>
                </c:pt>
                <c:pt idx="3">
                  <c:v>25.925925925925913</c:v>
                </c:pt>
                <c:pt idx="4">
                  <c:v>-20</c:v>
                </c:pt>
                <c:pt idx="5">
                  <c:v>-30.95238095238096</c:v>
                </c:pt>
                <c:pt idx="6">
                  <c:v>-4.0816326530612272</c:v>
                </c:pt>
              </c:numCache>
            </c:numRef>
          </c:xVal>
          <c:yVal>
            <c:numRef>
              <c:f>'RLP-C作図'!$X$33:$X$39</c:f>
              <c:numCache>
                <c:formatCode>General</c:formatCode>
                <c:ptCount val="7"/>
                <c:pt idx="0">
                  <c:v>-14.451476793248949</c:v>
                </c:pt>
                <c:pt idx="1">
                  <c:v>33.34038950042337</c:v>
                </c:pt>
                <c:pt idx="2">
                  <c:v>-19.745395449620794</c:v>
                </c:pt>
                <c:pt idx="3">
                  <c:v>-6.0121594235532632</c:v>
                </c:pt>
                <c:pt idx="4">
                  <c:v>9.3767867352773031</c:v>
                </c:pt>
                <c:pt idx="5">
                  <c:v>9.2771084337349485</c:v>
                </c:pt>
                <c:pt idx="6">
                  <c:v>31.0829817158931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425632"/>
        <c:axId val="203426192"/>
      </c:scatterChart>
      <c:valAx>
        <c:axId val="2034256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3426192"/>
        <c:crosses val="autoZero"/>
        <c:crossBetween val="midCat"/>
      </c:valAx>
      <c:valAx>
        <c:axId val="203426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34256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O$23:$O$31</c:f>
              <c:numCache>
                <c:formatCode>General</c:formatCode>
                <c:ptCount val="9"/>
                <c:pt idx="0">
                  <c:v>-35.454545454545453</c:v>
                </c:pt>
                <c:pt idx="1">
                  <c:v>25.274725274725274</c:v>
                </c:pt>
                <c:pt idx="2">
                  <c:v>-30.708661417322837</c:v>
                </c:pt>
                <c:pt idx="3">
                  <c:v>0</c:v>
                </c:pt>
                <c:pt idx="4">
                  <c:v>-34.523809523809526</c:v>
                </c:pt>
                <c:pt idx="5">
                  <c:v>-29.545454545454547</c:v>
                </c:pt>
                <c:pt idx="6">
                  <c:v>-23.157894736842106</c:v>
                </c:pt>
                <c:pt idx="7">
                  <c:v>-26.190476190476193</c:v>
                </c:pt>
                <c:pt idx="8">
                  <c:v>-61.570247933884289</c:v>
                </c:pt>
              </c:numCache>
            </c:numRef>
          </c:xVal>
          <c:yVal>
            <c:numRef>
              <c:f>TG作図!$P$23:$P$31</c:f>
              <c:numCache>
                <c:formatCode>General</c:formatCode>
                <c:ptCount val="9"/>
                <c:pt idx="0">
                  <c:v>-12.181303116147301</c:v>
                </c:pt>
                <c:pt idx="1">
                  <c:v>-7.4128984432913274</c:v>
                </c:pt>
                <c:pt idx="2">
                  <c:v>-8.6603518267929704</c:v>
                </c:pt>
                <c:pt idx="3">
                  <c:v>-34.063047285464101</c:v>
                </c:pt>
                <c:pt idx="4">
                  <c:v>-28.832951945080094</c:v>
                </c:pt>
                <c:pt idx="5">
                  <c:v>-20</c:v>
                </c:pt>
                <c:pt idx="6">
                  <c:v>-8.3400160384923865</c:v>
                </c:pt>
                <c:pt idx="7">
                  <c:v>0.41753653444677002</c:v>
                </c:pt>
                <c:pt idx="8">
                  <c:v>1.11731843575417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859328"/>
        <c:axId val="188859888"/>
      </c:scatterChart>
      <c:valAx>
        <c:axId val="1888593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859888"/>
        <c:crosses val="autoZero"/>
        <c:crossBetween val="midCat"/>
      </c:valAx>
      <c:valAx>
        <c:axId val="188859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8593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Q$23:$Q$31</c:f>
              <c:numCache>
                <c:formatCode>General</c:formatCode>
                <c:ptCount val="9"/>
                <c:pt idx="0">
                  <c:v>26.760563380281688</c:v>
                </c:pt>
                <c:pt idx="1">
                  <c:v>-29.82456140350877</c:v>
                </c:pt>
                <c:pt idx="2">
                  <c:v>19.318181818181817</c:v>
                </c:pt>
                <c:pt idx="3">
                  <c:v>-19.753086419753085</c:v>
                </c:pt>
                <c:pt idx="4">
                  <c:v>36.363636363636367</c:v>
                </c:pt>
                <c:pt idx="5">
                  <c:v>16.129032258064516</c:v>
                </c:pt>
                <c:pt idx="6">
                  <c:v>-10.95890410958904</c:v>
                </c:pt>
                <c:pt idx="7">
                  <c:v>-11.827956989247312</c:v>
                </c:pt>
                <c:pt idx="8">
                  <c:v>5.376344086021505</c:v>
                </c:pt>
              </c:numCache>
            </c:numRef>
          </c:xVal>
          <c:yVal>
            <c:numRef>
              <c:f>TG作図!$R$23:$R$31</c:f>
              <c:numCache>
                <c:formatCode>General</c:formatCode>
                <c:ptCount val="9"/>
                <c:pt idx="0">
                  <c:v>-2.9032258064516081</c:v>
                </c:pt>
                <c:pt idx="1">
                  <c:v>15.452361889511595</c:v>
                </c:pt>
                <c:pt idx="2">
                  <c:v>-18.370370370370367</c:v>
                </c:pt>
                <c:pt idx="3">
                  <c:v>29.614873837981403</c:v>
                </c:pt>
                <c:pt idx="4">
                  <c:v>12.861736334405144</c:v>
                </c:pt>
                <c:pt idx="5">
                  <c:v>-2.9411764705882382</c:v>
                </c:pt>
                <c:pt idx="6">
                  <c:v>-6.9116360454943058</c:v>
                </c:pt>
                <c:pt idx="7">
                  <c:v>19.95841995841996</c:v>
                </c:pt>
                <c:pt idx="8">
                  <c:v>-3.31491712707181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862128"/>
        <c:axId val="188862688"/>
      </c:scatterChart>
      <c:valAx>
        <c:axId val="1888621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862688"/>
        <c:crosses val="autoZero"/>
        <c:crossBetween val="midCat"/>
      </c:valAx>
      <c:valAx>
        <c:axId val="1888626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8621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G作図!$S$23:$S$31</c:f>
              <c:numCache>
                <c:formatCode>General</c:formatCode>
                <c:ptCount val="9"/>
                <c:pt idx="0">
                  <c:v>92.222222222222229</c:v>
                </c:pt>
                <c:pt idx="1">
                  <c:v>2.5</c:v>
                </c:pt>
                <c:pt idx="2">
                  <c:v>3.8095238095238098</c:v>
                </c:pt>
                <c:pt idx="3">
                  <c:v>23.076923076923077</c:v>
                </c:pt>
                <c:pt idx="4">
                  <c:v>-14.666666666666666</c:v>
                </c:pt>
                <c:pt idx="5">
                  <c:v>8.3333333333333321</c:v>
                </c:pt>
                <c:pt idx="6">
                  <c:v>32.307692307692307</c:v>
                </c:pt>
                <c:pt idx="7">
                  <c:v>-1.2195121951219512</c:v>
                </c:pt>
                <c:pt idx="8">
                  <c:v>37.755102040816325</c:v>
                </c:pt>
              </c:numCache>
            </c:numRef>
          </c:xVal>
          <c:yVal>
            <c:numRef>
              <c:f>TG作図!$T$23:$T$31</c:f>
              <c:numCache>
                <c:formatCode>General</c:formatCode>
                <c:ptCount val="9"/>
                <c:pt idx="0">
                  <c:v>-11.461794019933564</c:v>
                </c:pt>
                <c:pt idx="1">
                  <c:v>-3.5367545076282902</c:v>
                </c:pt>
                <c:pt idx="2">
                  <c:v>13.248638838475493</c:v>
                </c:pt>
                <c:pt idx="3">
                  <c:v>-19.262295081967213</c:v>
                </c:pt>
                <c:pt idx="4">
                  <c:v>6.6951566951566992</c:v>
                </c:pt>
                <c:pt idx="5">
                  <c:v>-3.7878787878787881</c:v>
                </c:pt>
                <c:pt idx="6">
                  <c:v>-5.6390977443609023</c:v>
                </c:pt>
                <c:pt idx="7">
                  <c:v>-23.050259965337961</c:v>
                </c:pt>
                <c:pt idx="8">
                  <c:v>-8.00000000000000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864928"/>
        <c:axId val="189463584"/>
      </c:scatterChart>
      <c:valAx>
        <c:axId val="1888649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463584"/>
        <c:crosses val="autoZero"/>
        <c:crossBetween val="midCat"/>
      </c:valAx>
      <c:valAx>
        <c:axId val="189463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88649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L$23:$L$31</c:f>
              <c:numCache>
                <c:formatCode>General</c:formatCode>
                <c:ptCount val="9"/>
                <c:pt idx="0">
                  <c:v>-46.739130434782602</c:v>
                </c:pt>
                <c:pt idx="1">
                  <c:v>-32.258064516129039</c:v>
                </c:pt>
                <c:pt idx="2">
                  <c:v>-55.882352941176471</c:v>
                </c:pt>
                <c:pt idx="3">
                  <c:v>-55.072463768115945</c:v>
                </c:pt>
                <c:pt idx="4">
                  <c:v>-45</c:v>
                </c:pt>
                <c:pt idx="5">
                  <c:v>-44.44444444444445</c:v>
                </c:pt>
                <c:pt idx="6">
                  <c:v>-50.632911392405056</c:v>
                </c:pt>
                <c:pt idx="7">
                  <c:v>-47.222222222222229</c:v>
                </c:pt>
                <c:pt idx="8">
                  <c:v>-79.428571428571431</c:v>
                </c:pt>
              </c:numCache>
            </c:numRef>
          </c:xVal>
          <c:yVal>
            <c:numRef>
              <c:f>'RLP-C作図'!$M$23:$M$31</c:f>
              <c:numCache>
                <c:formatCode>General</c:formatCode>
                <c:ptCount val="9"/>
                <c:pt idx="0">
                  <c:v>-12.181303116147301</c:v>
                </c:pt>
                <c:pt idx="1">
                  <c:v>-7.4128984432913274</c:v>
                </c:pt>
                <c:pt idx="2">
                  <c:v>-8.6603518267929704</c:v>
                </c:pt>
                <c:pt idx="3">
                  <c:v>-34.063047285464101</c:v>
                </c:pt>
                <c:pt idx="4">
                  <c:v>-28.832951945080094</c:v>
                </c:pt>
                <c:pt idx="5">
                  <c:v>-20</c:v>
                </c:pt>
                <c:pt idx="6">
                  <c:v>-8.3400160384923865</c:v>
                </c:pt>
                <c:pt idx="7">
                  <c:v>0.41753653444677002</c:v>
                </c:pt>
                <c:pt idx="8">
                  <c:v>1.11731843575417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465824"/>
        <c:axId val="189466384"/>
      </c:scatterChart>
      <c:valAx>
        <c:axId val="189465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466384"/>
        <c:crosses val="autoZero"/>
        <c:crossBetween val="midCat"/>
      </c:valAx>
      <c:valAx>
        <c:axId val="189466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4658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N$23:$N$31</c:f>
              <c:numCache>
                <c:formatCode>General</c:formatCode>
                <c:ptCount val="9"/>
                <c:pt idx="0">
                  <c:v>-20.408163265306133</c:v>
                </c:pt>
                <c:pt idx="1">
                  <c:v>-46.031746031746032</c:v>
                </c:pt>
                <c:pt idx="2">
                  <c:v>3.3333333333333361</c:v>
                </c:pt>
                <c:pt idx="3">
                  <c:v>-3.2258064516129057</c:v>
                </c:pt>
                <c:pt idx="4">
                  <c:v>-27.27272727272727</c:v>
                </c:pt>
                <c:pt idx="5">
                  <c:v>2.4999999999999911</c:v>
                </c:pt>
                <c:pt idx="6">
                  <c:v>-23.076923076923077</c:v>
                </c:pt>
                <c:pt idx="7">
                  <c:v>-31.578947368421044</c:v>
                </c:pt>
                <c:pt idx="8">
                  <c:v>5.5555555555555483</c:v>
                </c:pt>
              </c:numCache>
            </c:numRef>
          </c:xVal>
          <c:yVal>
            <c:numRef>
              <c:f>'RLP-C作図'!$O$23:$O$31</c:f>
              <c:numCache>
                <c:formatCode>General</c:formatCode>
                <c:ptCount val="9"/>
                <c:pt idx="0">
                  <c:v>-2.9032258064516081</c:v>
                </c:pt>
                <c:pt idx="1">
                  <c:v>15.452361889511595</c:v>
                </c:pt>
                <c:pt idx="2">
                  <c:v>-18.370370370370367</c:v>
                </c:pt>
                <c:pt idx="3">
                  <c:v>29.614873837981403</c:v>
                </c:pt>
                <c:pt idx="4">
                  <c:v>12.861736334405144</c:v>
                </c:pt>
                <c:pt idx="5">
                  <c:v>-2.9411764705882382</c:v>
                </c:pt>
                <c:pt idx="6">
                  <c:v>-6.9116360454943058</c:v>
                </c:pt>
                <c:pt idx="7">
                  <c:v>19.95841995841996</c:v>
                </c:pt>
                <c:pt idx="8">
                  <c:v>-3.31491712707181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469184"/>
        <c:axId val="189469744"/>
      </c:scatterChart>
      <c:valAx>
        <c:axId val="1894691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469744"/>
        <c:crosses val="autoZero"/>
        <c:crossBetween val="midCat"/>
      </c:valAx>
      <c:valAx>
        <c:axId val="1894697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4691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LP-C作図'!$P$23:$P$31</c:f>
              <c:numCache>
                <c:formatCode>General</c:formatCode>
                <c:ptCount val="9"/>
                <c:pt idx="0">
                  <c:v>82.051282051282044</c:v>
                </c:pt>
                <c:pt idx="1">
                  <c:v>44.117647058823543</c:v>
                </c:pt>
                <c:pt idx="2">
                  <c:v>-100</c:v>
                </c:pt>
                <c:pt idx="3">
                  <c:v>-9.9999999999999929</c:v>
                </c:pt>
                <c:pt idx="4">
                  <c:v>37.5</c:v>
                </c:pt>
                <c:pt idx="5">
                  <c:v>36.585365853658544</c:v>
                </c:pt>
                <c:pt idx="6">
                  <c:v>30</c:v>
                </c:pt>
                <c:pt idx="7">
                  <c:v>-23.076923076923077</c:v>
                </c:pt>
                <c:pt idx="8">
                  <c:v>23.684210526315798</c:v>
                </c:pt>
              </c:numCache>
            </c:numRef>
          </c:xVal>
          <c:yVal>
            <c:numRef>
              <c:f>'RLP-C作図'!$Q$23:$Q$31</c:f>
              <c:numCache>
                <c:formatCode>General</c:formatCode>
                <c:ptCount val="9"/>
                <c:pt idx="0">
                  <c:v>-11.461794019933564</c:v>
                </c:pt>
                <c:pt idx="1">
                  <c:v>-3.5367545076282902</c:v>
                </c:pt>
                <c:pt idx="2">
                  <c:v>13.248638838475493</c:v>
                </c:pt>
                <c:pt idx="3">
                  <c:v>-19.262295081967213</c:v>
                </c:pt>
                <c:pt idx="4">
                  <c:v>6.6951566951566992</c:v>
                </c:pt>
                <c:pt idx="5">
                  <c:v>-3.7878787878787881</c:v>
                </c:pt>
                <c:pt idx="6">
                  <c:v>-5.6390977443609023</c:v>
                </c:pt>
                <c:pt idx="7">
                  <c:v>-23.050259965337961</c:v>
                </c:pt>
                <c:pt idx="8">
                  <c:v>-8.00000000000000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885216"/>
        <c:axId val="190885776"/>
      </c:scatterChart>
      <c:valAx>
        <c:axId val="1908852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85776"/>
        <c:crosses val="autoZero"/>
        <c:crossBetween val="midCat"/>
      </c:valAx>
      <c:valAx>
        <c:axId val="190885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08852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762A24-C054-40A8-8E14-AF6BA430ECFF}" type="datetimeFigureOut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F8574C-4DAC-4A05-914C-7C6DA15BCD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366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F8574C-4DAC-4A05-914C-7C6DA15BCD3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397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45DDE-2A95-4D1B-9D1E-3CA1BD43872F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511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02A88-FAA8-401B-B15A-B745A1575444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288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F5E9E-060E-464E-9D81-006C21307658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495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29D02-8FFE-4273-B0AC-EF22C3F95EC0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16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5B675-AF81-478D-A318-596BEE61E080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10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2C67-F1BF-4439-ACB2-AF4DFBA58AF1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05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CDED8-3551-49F2-A380-0B92217835B4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16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84869-AC15-42C7-9EC0-51916CF18E63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036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FD13A-98DB-4D51-B47B-CDE58D4C317C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970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7EE8C-2A1E-4AB6-B3F9-CCF95ECE018F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474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8DB18-E52D-47C5-8C59-B9A1B9143285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367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C6C40-81BD-47DC-A053-4C46D08472C4}" type="datetime1">
              <a:rPr kumimoji="1" lang="ja-JP" altLang="en-US" smtClean="0"/>
              <a:t>2016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22C6FE-6413-418B-9DFD-F5849AC415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9274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9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0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5.xml"/><Relationship Id="rId2" Type="http://schemas.openxmlformats.org/officeDocument/2006/relationships/chart" Target="../charts/chart3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3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4405313" y="178522"/>
            <a:ext cx="3143681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600" b="1" dirty="0">
                <a:latin typeface="+mn-lt"/>
                <a:ea typeface="+mn-ea"/>
              </a:rPr>
              <a:t>ONLINE SUPPLEMENTAL MATERIAL</a:t>
            </a:r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254000" y="695531"/>
            <a:ext cx="114046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ja-JP" sz="2400" b="1"/>
              <a:t>Changes </a:t>
            </a:r>
            <a:r>
              <a:rPr lang="en-US" altLang="ja-JP" sz="2400" b="1" smtClean="0"/>
              <a:t>in</a:t>
            </a:r>
            <a:r>
              <a:rPr lang="en-US" altLang="ja-JP" sz="2400" b="1" smtClean="0"/>
              <a:t> </a:t>
            </a:r>
            <a:r>
              <a:rPr lang="en-US" altLang="ja-JP" sz="2400" b="1" dirty="0"/>
              <a:t>lipoprotein lipase and endothelial lipase mass in familial hypercholesterolemia during three-drug lipid-lowering combination therapy</a:t>
            </a:r>
            <a:endParaRPr lang="en-US" altLang="ja-JP" sz="2400" dirty="0"/>
          </a:p>
        </p:txBody>
      </p:sp>
      <p:sp>
        <p:nvSpPr>
          <p:cNvPr id="6" name="テキスト ボックス 1"/>
          <p:cNvSpPr txBox="1">
            <a:spLocks noChangeArrowheads="1"/>
          </p:cNvSpPr>
          <p:nvPr/>
        </p:nvSpPr>
        <p:spPr bwMode="auto">
          <a:xfrm>
            <a:off x="11152544" y="1947319"/>
            <a:ext cx="393056" cy="445763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>
              <a:spcBef>
                <a:spcPts val="900"/>
              </a:spcBef>
            </a:pPr>
            <a:r>
              <a:rPr lang="en-US" altLang="ja-JP" sz="1600" dirty="0"/>
              <a:t>2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/>
              <a:t>3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/>
              <a:t>4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/>
              <a:t>5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6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7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8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9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10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11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12</a:t>
            </a:r>
          </a:p>
          <a:p>
            <a:pPr algn="r">
              <a:spcBef>
                <a:spcPts val="900"/>
              </a:spcBef>
            </a:pPr>
            <a:r>
              <a:rPr lang="en-US" altLang="ja-JP" sz="1600" dirty="0" smtClean="0"/>
              <a:t>13</a:t>
            </a:r>
            <a:endParaRPr lang="en-US" altLang="ja-JP" sz="1600" dirty="0"/>
          </a:p>
        </p:txBody>
      </p:sp>
      <p:sp>
        <p:nvSpPr>
          <p:cNvPr id="8" name="スライド番号プレースホルダー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1</a:t>
            </a:fld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81000" y="1884973"/>
            <a:ext cx="109833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1. Associations between the changes in LPL mass and those in LDL cholesterol (Group 1)……………………………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81000" y="2249139"/>
            <a:ext cx="109946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2. Associations between the changes in LPL mass and those in TG (Group 1)……………………………………………….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81000" y="2613305"/>
            <a:ext cx="109914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3. Associations between the changes in LPL mass and those in </a:t>
            </a:r>
            <a:r>
              <a:rPr lang="en-US" altLang="ja-JP" sz="1600" b="1" dirty="0" smtClean="0"/>
              <a:t>RLP</a:t>
            </a:r>
            <a:r>
              <a:rPr kumimoji="1" lang="en-US" altLang="ja-JP" sz="1600" b="1" dirty="0" smtClean="0"/>
              <a:t> cholesterol (Group 1)……………………………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81000" y="2977471"/>
            <a:ext cx="109833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4. Associations between the changes in LPL mass and those in LDL cholesterol (Group 2)…………………………….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81000" y="3341637"/>
            <a:ext cx="109946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/>
              <a:t>5</a:t>
            </a:r>
            <a:r>
              <a:rPr kumimoji="1" lang="en-US" altLang="ja-JP" sz="1600" b="1" dirty="0" smtClean="0"/>
              <a:t>. Associations between the changes in LPL mass and those in TG (Group </a:t>
            </a:r>
            <a:r>
              <a:rPr lang="en-US" altLang="ja-JP" sz="1600" b="1" dirty="0" smtClean="0"/>
              <a:t>2</a:t>
            </a:r>
            <a:r>
              <a:rPr kumimoji="1" lang="en-US" altLang="ja-JP" sz="1600" b="1" dirty="0" smtClean="0"/>
              <a:t>)……………………………………………….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81000" y="3705803"/>
            <a:ext cx="109914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/>
              <a:t>6</a:t>
            </a:r>
            <a:r>
              <a:rPr kumimoji="1" lang="en-US" altLang="ja-JP" sz="1600" b="1" dirty="0" smtClean="0"/>
              <a:t>. Associations between the changes in LPL mass and those in </a:t>
            </a:r>
            <a:r>
              <a:rPr lang="en-US" altLang="ja-JP" sz="1600" b="1" dirty="0" smtClean="0"/>
              <a:t>RLP</a:t>
            </a:r>
            <a:r>
              <a:rPr kumimoji="1" lang="en-US" altLang="ja-JP" sz="1600" b="1" dirty="0" smtClean="0"/>
              <a:t> cholesterol (Group 2)……………………………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1000" y="4069969"/>
            <a:ext cx="109417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7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LDL cholesterol (Group 1)……………………………..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81000" y="4434135"/>
            <a:ext cx="109898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/>
              <a:t>8</a:t>
            </a:r>
            <a:r>
              <a:rPr kumimoji="1" lang="en-US" altLang="ja-JP" sz="1600" b="1" dirty="0" smtClean="0"/>
              <a:t>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TG (Group 1)…………………………………………………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81000" y="4798301"/>
            <a:ext cx="10949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/>
              <a:t>9</a:t>
            </a:r>
            <a:r>
              <a:rPr kumimoji="1" lang="en-US" altLang="ja-JP" sz="1600" b="1" dirty="0" smtClean="0"/>
              <a:t>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</a:t>
            </a:r>
            <a:r>
              <a:rPr lang="en-US" altLang="ja-JP" sz="1600" b="1" dirty="0" smtClean="0"/>
              <a:t>RLP</a:t>
            </a:r>
            <a:r>
              <a:rPr kumimoji="1" lang="en-US" altLang="ja-JP" sz="1600" b="1" dirty="0" smtClean="0"/>
              <a:t> cholesterol (Group 1)……………………………..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81000" y="5162467"/>
            <a:ext cx="109914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 smtClean="0"/>
              <a:t>10</a:t>
            </a:r>
            <a:r>
              <a:rPr kumimoji="1" lang="en-US" altLang="ja-JP" sz="1600" b="1" dirty="0" smtClean="0"/>
              <a:t>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LDL cholesterol (Group 2)……………………………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81000" y="5526633"/>
            <a:ext cx="110026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 smtClean="0"/>
              <a:t>11</a:t>
            </a:r>
            <a:r>
              <a:rPr kumimoji="1" lang="en-US" altLang="ja-JP" sz="1600" b="1" dirty="0" smtClean="0"/>
              <a:t>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TG (Group </a:t>
            </a:r>
            <a:r>
              <a:rPr lang="en-US" altLang="ja-JP" sz="1600" b="1" dirty="0" smtClean="0"/>
              <a:t>2</a:t>
            </a:r>
            <a:r>
              <a:rPr kumimoji="1" lang="en-US" altLang="ja-JP" sz="1600" b="1" dirty="0" smtClean="0"/>
              <a:t>)……………………………………………….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81000" y="5890796"/>
            <a:ext cx="109994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Supplemental Figure </a:t>
            </a:r>
            <a:r>
              <a:rPr lang="en-US" altLang="ja-JP" sz="1600" b="1" dirty="0" smtClean="0"/>
              <a:t>12</a:t>
            </a:r>
            <a:r>
              <a:rPr kumimoji="1" lang="en-US" altLang="ja-JP" sz="1600" b="1" dirty="0" smtClean="0"/>
              <a:t>. Associations between the changes in </a:t>
            </a:r>
            <a:r>
              <a:rPr lang="en-US" altLang="ja-JP" sz="1600" b="1" dirty="0" smtClean="0"/>
              <a:t>EL</a:t>
            </a:r>
            <a:r>
              <a:rPr kumimoji="1" lang="en-US" altLang="ja-JP" sz="1600" b="1" dirty="0" smtClean="0"/>
              <a:t> mass and those in </a:t>
            </a:r>
            <a:r>
              <a:rPr lang="en-US" altLang="ja-JP" sz="1600" b="1" dirty="0" smtClean="0"/>
              <a:t>RLP</a:t>
            </a:r>
            <a:r>
              <a:rPr kumimoji="1" lang="en-US" altLang="ja-JP" sz="1600" b="1" dirty="0" smtClean="0"/>
              <a:t> cholesterol (Group 2)……………………………</a:t>
            </a:r>
          </a:p>
        </p:txBody>
      </p:sp>
    </p:spTree>
    <p:extLst>
      <p:ext uri="{BB962C8B-B14F-4D97-AF65-F5344CB8AC3E}">
        <p14:creationId xmlns:p14="http://schemas.microsoft.com/office/powerpoint/2010/main" val="3567964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グラフ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2941799"/>
              </p:ext>
            </p:extLst>
          </p:nvPr>
        </p:nvGraphicFramePr>
        <p:xfrm>
          <a:off x="247961" y="1506684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366345"/>
              </p:ext>
            </p:extLst>
          </p:nvPr>
        </p:nvGraphicFramePr>
        <p:xfrm>
          <a:off x="4217468" y="1506684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311013"/>
              </p:ext>
            </p:extLst>
          </p:nvPr>
        </p:nvGraphicFramePr>
        <p:xfrm>
          <a:off x="8186974" y="1506684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スライド番号プレースホルダー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10</a:t>
            </a:fld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9. Associations between the changes in EL mass and those in RLP cholesterol (Group 1)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50403" y="5062218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 rot="-5400000">
            <a:off x="-1261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183016" y="5047654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184837" y="5016481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 rot="-5400000">
            <a:off x="6714700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15963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6223852"/>
              </p:ext>
            </p:extLst>
          </p:nvPr>
        </p:nvGraphicFramePr>
        <p:xfrm>
          <a:off x="399824" y="1476480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2389131"/>
              </p:ext>
            </p:extLst>
          </p:nvPr>
        </p:nvGraphicFramePr>
        <p:xfrm>
          <a:off x="4305131" y="14774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2028525"/>
              </p:ext>
            </p:extLst>
          </p:nvPr>
        </p:nvGraphicFramePr>
        <p:xfrm>
          <a:off x="8318713" y="1476480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11</a:t>
            </a:fld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10. Associations between the changes in EL mass and those in LDL cholesterol (Group 2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62839" y="5062218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 rot="-5400000">
            <a:off x="-1134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326182" y="5047654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32" name="テキスト ボックス 31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8334927" y="5016481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 rot="-5400000">
            <a:off x="6745873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99180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2280053"/>
              </p:ext>
            </p:extLst>
          </p:nvPr>
        </p:nvGraphicFramePr>
        <p:xfrm>
          <a:off x="460667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2599496"/>
              </p:ext>
            </p:extLst>
          </p:nvPr>
        </p:nvGraphicFramePr>
        <p:xfrm>
          <a:off x="4409613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0610127"/>
              </p:ext>
            </p:extLst>
          </p:nvPr>
        </p:nvGraphicFramePr>
        <p:xfrm>
          <a:off x="8358558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12</a:t>
            </a:fld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571539" y="435535"/>
            <a:ext cx="929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11. Associations between the changes in EL mass and those in TG (Group 2)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970839" y="5062218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 rot="-5400000">
            <a:off x="-1261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854964" y="5047654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755183" y="5016481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 rot="-5400000">
            <a:off x="6714700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16992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0866411"/>
              </p:ext>
            </p:extLst>
          </p:nvPr>
        </p:nvGraphicFramePr>
        <p:xfrm>
          <a:off x="379995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0134659"/>
              </p:ext>
            </p:extLst>
          </p:nvPr>
        </p:nvGraphicFramePr>
        <p:xfrm>
          <a:off x="4356222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5332446"/>
              </p:ext>
            </p:extLst>
          </p:nvPr>
        </p:nvGraphicFramePr>
        <p:xfrm>
          <a:off x="8332448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13</a:t>
            </a:fld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12. Associations between the changes in EL mass and those in RLP cholesterol (Group 2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50403" y="5062218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 rot="-5400000">
            <a:off x="-1261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183016" y="5047654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8184837" y="5016481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 rot="-5400000">
            <a:off x="6714700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36002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0430817"/>
              </p:ext>
            </p:extLst>
          </p:nvPr>
        </p:nvGraphicFramePr>
        <p:xfrm>
          <a:off x="4224193" y="154470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7507849"/>
              </p:ext>
            </p:extLst>
          </p:nvPr>
        </p:nvGraphicFramePr>
        <p:xfrm>
          <a:off x="8225194" y="154470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1. Associations between the changes in LPL mass and those in LDL cholesterol (Group 1)</a:t>
            </a:r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7390827"/>
              </p:ext>
            </p:extLst>
          </p:nvPr>
        </p:nvGraphicFramePr>
        <p:xfrm>
          <a:off x="223191" y="154470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244628" y="5062218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2</a:t>
            </a:fld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234971" y="5047654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220626" y="5016481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 rot="-5400000">
            <a:off x="6662603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78911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89828"/>
              </p:ext>
            </p:extLst>
          </p:nvPr>
        </p:nvGraphicFramePr>
        <p:xfrm>
          <a:off x="230375" y="1485239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3144483"/>
              </p:ext>
            </p:extLst>
          </p:nvPr>
        </p:nvGraphicFramePr>
        <p:xfrm>
          <a:off x="4281411" y="1485239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8239170"/>
              </p:ext>
            </p:extLst>
          </p:nvPr>
        </p:nvGraphicFramePr>
        <p:xfrm>
          <a:off x="8332447" y="1485239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3</a:t>
            </a:fld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571539" y="435535"/>
            <a:ext cx="929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2. Associations between the changes in LPL mass and those in TG (Group 1)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16129" y="5062218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838798" y="5047654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3" name="テキスト ボックス 22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855626" y="5016481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 rot="-5400000">
            <a:off x="6662603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25281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318192"/>
              </p:ext>
            </p:extLst>
          </p:nvPr>
        </p:nvGraphicFramePr>
        <p:xfrm>
          <a:off x="238154" y="1506683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2766958"/>
              </p:ext>
            </p:extLst>
          </p:nvPr>
        </p:nvGraphicFramePr>
        <p:xfrm>
          <a:off x="4219256" y="1506683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8857386"/>
              </p:ext>
            </p:extLst>
          </p:nvPr>
        </p:nvGraphicFramePr>
        <p:xfrm>
          <a:off x="8207756" y="1506683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4</a:t>
            </a:fld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971376" y="435535"/>
            <a:ext cx="104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3. Associations between the changes in LPL mass and those in RLP cholesterol (Group 1)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44628" y="5062218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234971" y="5047654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3" name="テキスト ボックス 22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220626" y="5016481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 rot="-5400000">
            <a:off x="6662603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49401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7566354"/>
              </p:ext>
            </p:extLst>
          </p:nvPr>
        </p:nvGraphicFramePr>
        <p:xfrm>
          <a:off x="353409" y="155215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190866"/>
              </p:ext>
            </p:extLst>
          </p:nvPr>
        </p:nvGraphicFramePr>
        <p:xfrm>
          <a:off x="4226957" y="155215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2705401"/>
              </p:ext>
            </p:extLst>
          </p:nvPr>
        </p:nvGraphicFramePr>
        <p:xfrm>
          <a:off x="8100506" y="1552152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5</a:t>
            </a:fld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4. Associations between the changes in LPL mass and those in LDL cholesterol (Group 2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44628" y="5062218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23" name="テキスト ボックス 22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234971" y="5047654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8220626" y="5016481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 rot="-5400000">
            <a:off x="6537911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14272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3749504"/>
              </p:ext>
            </p:extLst>
          </p:nvPr>
        </p:nvGraphicFramePr>
        <p:xfrm>
          <a:off x="271720" y="1510788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グラフ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5058679"/>
              </p:ext>
            </p:extLst>
          </p:nvPr>
        </p:nvGraphicFramePr>
        <p:xfrm>
          <a:off x="4263571" y="1510788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5447527"/>
              </p:ext>
            </p:extLst>
          </p:nvPr>
        </p:nvGraphicFramePr>
        <p:xfrm>
          <a:off x="8255421" y="1510788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6</a:t>
            </a:fld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71539" y="435535"/>
            <a:ext cx="929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5. Associations between the changes in LPL mass and those in TG (Group 2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16129" y="5062218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838798" y="5047654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855626" y="5016481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 rot="-5400000">
            <a:off x="6662603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08672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068817"/>
              </p:ext>
            </p:extLst>
          </p:nvPr>
        </p:nvGraphicFramePr>
        <p:xfrm>
          <a:off x="202444" y="1489276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9229812"/>
              </p:ext>
            </p:extLst>
          </p:nvPr>
        </p:nvGraphicFramePr>
        <p:xfrm>
          <a:off x="4256422" y="1489276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3564452"/>
              </p:ext>
            </p:extLst>
          </p:nvPr>
        </p:nvGraphicFramePr>
        <p:xfrm>
          <a:off x="8310400" y="1489276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7</a:t>
            </a:fld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971376" y="435535"/>
            <a:ext cx="104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6. Associations between the changes in LPL mass and those in RLP cholesterol (Group 2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44628" y="5062218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 rot="-5400000">
            <a:off x="-1313395" y="3088504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234971" y="5047654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 rot="-5400000">
            <a:off x="2676948" y="3073940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220626" y="5016481"/>
            <a:ext cx="3700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RLP cholesterol (%)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 rot="-5400000">
            <a:off x="6662603" y="3042767"/>
            <a:ext cx="310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LP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35157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6885822"/>
              </p:ext>
            </p:extLst>
          </p:nvPr>
        </p:nvGraphicFramePr>
        <p:xfrm>
          <a:off x="4369132" y="1510227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7157131"/>
              </p:ext>
            </p:extLst>
          </p:nvPr>
        </p:nvGraphicFramePr>
        <p:xfrm>
          <a:off x="335810" y="1510227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2179304"/>
              </p:ext>
            </p:extLst>
          </p:nvPr>
        </p:nvGraphicFramePr>
        <p:xfrm>
          <a:off x="8402454" y="1510227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スライド番号プレースホルダー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8</a:t>
            </a:fld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62839" y="5062218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 rot="-5400000">
            <a:off x="-1261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453182" y="5047654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438837" y="5016481"/>
            <a:ext cx="3696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LDL cholesterol (%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 rot="-5400000">
            <a:off x="6714700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48131" y="435535"/>
            <a:ext cx="10546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7. Associations between the changes in EL mass and those in LDL cholesterol (Group 1)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32848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8598586"/>
              </p:ext>
            </p:extLst>
          </p:nvPr>
        </p:nvGraphicFramePr>
        <p:xfrm>
          <a:off x="334140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3100086"/>
              </p:ext>
            </p:extLst>
          </p:nvPr>
        </p:nvGraphicFramePr>
        <p:xfrm>
          <a:off x="4292561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0901521"/>
              </p:ext>
            </p:extLst>
          </p:nvPr>
        </p:nvGraphicFramePr>
        <p:xfrm>
          <a:off x="8250982" y="1438051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スライド番号プレースホルダー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C6FE-6413-418B-9DFD-F5849AC4155D}" type="slidenum">
              <a:rPr kumimoji="1" lang="ja-JP" altLang="en-US" smtClean="0"/>
              <a:t>9</a:t>
            </a:fld>
            <a:endParaRPr kumimoji="1" lang="ja-JP" altLang="en-US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571539" y="435535"/>
            <a:ext cx="929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Supplemental Figure 8. Associations between the changes in EL mass and those in TG (Group 1)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94517" y="12622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151108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154245" y="126227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/>
              <a:t>C</a:t>
            </a:r>
            <a:endParaRPr kumimoji="1" lang="ja-JP" alt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970839" y="5062218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 rot="-5400000">
            <a:off x="-1261298" y="3088504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854964" y="5047654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 rot="-5400000">
            <a:off x="2729045" y="3073940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755183" y="5016481"/>
            <a:ext cx="25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ercent change in TG (%)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 rot="-5400000">
            <a:off x="6714700" y="3042767"/>
            <a:ext cx="3005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Percent change in EL mass </a:t>
            </a:r>
            <a:r>
              <a:rPr kumimoji="1" lang="en-US" altLang="ja-JP" dirty="0" smtClean="0"/>
              <a:t>(%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26151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973</Words>
  <Application>Microsoft Office PowerPoint</Application>
  <PresentationFormat>ワイド画面</PresentationFormat>
  <Paragraphs>160</Paragraphs>
  <Slides>1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8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Kanazawa Univ.(2014.07.09)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yato</dc:creator>
  <cp:lastModifiedBy>Hayato</cp:lastModifiedBy>
  <cp:revision>86</cp:revision>
  <dcterms:created xsi:type="dcterms:W3CDTF">2016-01-18T00:45:08Z</dcterms:created>
  <dcterms:modified xsi:type="dcterms:W3CDTF">2016-03-02T08:36:37Z</dcterms:modified>
</cp:coreProperties>
</file>